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60" r:id="rId2"/>
  </p:sldIdLst>
  <p:sldSz cx="12192000" cy="6858000"/>
  <p:notesSz cx="6807200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8000"/>
    <a:srgbClr val="C88EFF"/>
    <a:srgbClr val="FFFFCC"/>
    <a:srgbClr val="FFFFFF"/>
    <a:srgbClr val="FFCCCC"/>
    <a:srgbClr val="FF4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3A63F794-839C-4206-B70A-1BB4D7774E64}" v="3" dt="2024-08-13T10:17:43.51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006" autoAdjust="0"/>
    <p:restoredTop sz="94674"/>
  </p:normalViewPr>
  <p:slideViewPr>
    <p:cSldViewPr snapToGrid="0">
      <p:cViewPr varScale="1">
        <p:scale>
          <a:sx n="101" d="100"/>
          <a:sy n="101" d="100"/>
        </p:scale>
        <p:origin x="1080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>
      <p:cViewPr varScale="1">
        <p:scale>
          <a:sx n="77" d="100"/>
          <a:sy n="77" d="100"/>
        </p:scale>
        <p:origin x="4080" y="114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0" Type="http://schemas.microsoft.com/office/2015/10/relationships/revisionInfo" Target="revisionInfo.xml"/><Relationship Id="rId4" Type="http://schemas.openxmlformats.org/officeDocument/2006/relationships/handoutMaster" Target="handoutMasters/handoutMaster1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美香 三木" userId="0e1e0125d0a1c367" providerId="LiveId" clId="{4246EB31-AEA6-4A6F-A411-1296418A3280}"/>
    <pc:docChg chg="delSld">
      <pc:chgData name="美香 三木" userId="0e1e0125d0a1c367" providerId="LiveId" clId="{4246EB31-AEA6-4A6F-A411-1296418A3280}" dt="2024-02-07T02:01:47.785" v="0" actId="47"/>
      <pc:docMkLst>
        <pc:docMk/>
      </pc:docMkLst>
      <pc:sldChg chg="del">
        <pc:chgData name="美香 三木" userId="0e1e0125d0a1c367" providerId="LiveId" clId="{4246EB31-AEA6-4A6F-A411-1296418A3280}" dt="2024-02-07T02:01:47.785" v="0" actId="47"/>
        <pc:sldMkLst>
          <pc:docMk/>
          <pc:sldMk cId="3651008496" sldId="293"/>
        </pc:sldMkLst>
      </pc:sldChg>
    </pc:docChg>
  </pc:docChgLst>
  <pc:docChgLst>
    <pc:chgData name="美香 三木" userId="0e1e0125d0a1c367" providerId="LiveId" clId="{2C3C507E-2ED4-41A2-862A-8D1B503AFCFB}"/>
    <pc:docChg chg="modSld">
      <pc:chgData name="美香 三木" userId="0e1e0125d0a1c367" providerId="LiveId" clId="{2C3C507E-2ED4-41A2-862A-8D1B503AFCFB}" dt="2024-07-16T10:04:10.845" v="70" actId="208"/>
      <pc:docMkLst>
        <pc:docMk/>
      </pc:docMkLst>
      <pc:sldChg chg="modSp mod">
        <pc:chgData name="美香 三木" userId="0e1e0125d0a1c367" providerId="LiveId" clId="{2C3C507E-2ED4-41A2-862A-8D1B503AFCFB}" dt="2024-07-16T10:04:10.845" v="70" actId="208"/>
        <pc:sldMkLst>
          <pc:docMk/>
          <pc:sldMk cId="2905389099" sldId="260"/>
        </pc:sldMkLst>
        <pc:spChg chg="ord">
          <ac:chgData name="美香 三木" userId="0e1e0125d0a1c367" providerId="LiveId" clId="{2C3C507E-2ED4-41A2-862A-8D1B503AFCFB}" dt="2024-07-16T10:04:05.150" v="69" actId="167"/>
          <ac:spMkLst>
            <pc:docMk/>
            <pc:sldMk cId="2905389099" sldId="260"/>
            <ac:spMk id="40" creationId="{8B53E8FC-D365-0B32-7124-E5E0BE71C686}"/>
          </ac:spMkLst>
        </pc:spChg>
        <pc:spChg chg="mod">
          <ac:chgData name="美香 三木" userId="0e1e0125d0a1c367" providerId="LiveId" clId="{2C3C507E-2ED4-41A2-862A-8D1B503AFCFB}" dt="2024-07-16T10:03:43.202" v="68" actId="14100"/>
          <ac:spMkLst>
            <pc:docMk/>
            <pc:sldMk cId="2905389099" sldId="260"/>
            <ac:spMk id="49" creationId="{0AEF9CA2-87A0-C4A4-051B-6E85023C5868}"/>
          </ac:spMkLst>
        </pc:spChg>
        <pc:cxnChg chg="mod">
          <ac:chgData name="美香 三木" userId="0e1e0125d0a1c367" providerId="LiveId" clId="{2C3C507E-2ED4-41A2-862A-8D1B503AFCFB}" dt="2024-07-16T10:02:06.399" v="0" actId="208"/>
          <ac:cxnSpMkLst>
            <pc:docMk/>
            <pc:sldMk cId="2905389099" sldId="260"/>
            <ac:cxnSpMk id="13" creationId="{5CD483E4-D512-D781-3265-318C1C405351}"/>
          </ac:cxnSpMkLst>
        </pc:cxnChg>
        <pc:cxnChg chg="mod">
          <ac:chgData name="美香 三木" userId="0e1e0125d0a1c367" providerId="LiveId" clId="{2C3C507E-2ED4-41A2-862A-8D1B503AFCFB}" dt="2024-07-16T10:04:10.845" v="70" actId="208"/>
          <ac:cxnSpMkLst>
            <pc:docMk/>
            <pc:sldMk cId="2905389099" sldId="260"/>
            <ac:cxnSpMk id="48" creationId="{2E0A115A-6D5D-F07C-60DF-E14BC0CA39AF}"/>
          </ac:cxnSpMkLst>
        </pc:cxnChg>
      </pc:sldChg>
    </pc:docChg>
  </pc:docChgLst>
  <pc:docChgLst>
    <pc:chgData name="美香 三木" userId="0e1e0125d0a1c367" providerId="LiveId" clId="{3A63F794-839C-4206-B70A-1BB4D7774E64}"/>
    <pc:docChg chg="undo redo custSel modSld">
      <pc:chgData name="美香 三木" userId="0e1e0125d0a1c367" providerId="LiveId" clId="{3A63F794-839C-4206-B70A-1BB4D7774E64}" dt="2024-08-13T10:17:43.518" v="14" actId="164"/>
      <pc:docMkLst>
        <pc:docMk/>
      </pc:docMkLst>
      <pc:sldChg chg="addSp delSp modSp mod">
        <pc:chgData name="美香 三木" userId="0e1e0125d0a1c367" providerId="LiveId" clId="{3A63F794-839C-4206-B70A-1BB4D7774E64}" dt="2024-08-13T10:17:43.518" v="14" actId="164"/>
        <pc:sldMkLst>
          <pc:docMk/>
          <pc:sldMk cId="2905389099" sldId="260"/>
        </pc:sldMkLst>
        <pc:spChg chg="add del mod">
          <ac:chgData name="美香 三木" userId="0e1e0125d0a1c367" providerId="LiveId" clId="{3A63F794-839C-4206-B70A-1BB4D7774E64}" dt="2024-08-13T10:15:00.831" v="12"/>
          <ac:spMkLst>
            <pc:docMk/>
            <pc:sldMk cId="2905389099" sldId="260"/>
            <ac:spMk id="4" creationId="{CA4AB38C-2A50-38D1-DA4E-BC895BB82A15}"/>
          </ac:spMkLst>
        </pc:spChg>
        <pc:spChg chg="mod topLvl">
          <ac:chgData name="美香 三木" userId="0e1e0125d0a1c367" providerId="LiveId" clId="{3A63F794-839C-4206-B70A-1BB4D7774E64}" dt="2024-08-13T10:17:43.518" v="14" actId="164"/>
          <ac:spMkLst>
            <pc:docMk/>
            <pc:sldMk cId="2905389099" sldId="260"/>
            <ac:spMk id="18" creationId="{B0422F8D-E6AF-2D70-A20D-C06663B8D11B}"/>
          </ac:spMkLst>
        </pc:spChg>
        <pc:spChg chg="mod topLvl">
          <ac:chgData name="美香 三木" userId="0e1e0125d0a1c367" providerId="LiveId" clId="{3A63F794-839C-4206-B70A-1BB4D7774E64}" dt="2024-08-13T10:17:43.518" v="14" actId="164"/>
          <ac:spMkLst>
            <pc:docMk/>
            <pc:sldMk cId="2905389099" sldId="260"/>
            <ac:spMk id="34" creationId="{CED823C8-B7CB-7495-92A9-CC0FF7A9753D}"/>
          </ac:spMkLst>
        </pc:spChg>
        <pc:spChg chg="mod topLvl">
          <ac:chgData name="美香 三木" userId="0e1e0125d0a1c367" providerId="LiveId" clId="{3A63F794-839C-4206-B70A-1BB4D7774E64}" dt="2024-08-13T10:17:43.518" v="14" actId="164"/>
          <ac:spMkLst>
            <pc:docMk/>
            <pc:sldMk cId="2905389099" sldId="260"/>
            <ac:spMk id="35" creationId="{CA32A7DE-B83F-788E-5BED-95881470C895}"/>
          </ac:spMkLst>
        </pc:spChg>
        <pc:spChg chg="mod topLvl">
          <ac:chgData name="美香 三木" userId="0e1e0125d0a1c367" providerId="LiveId" clId="{3A63F794-839C-4206-B70A-1BB4D7774E64}" dt="2024-08-13T10:17:43.518" v="14" actId="164"/>
          <ac:spMkLst>
            <pc:docMk/>
            <pc:sldMk cId="2905389099" sldId="260"/>
            <ac:spMk id="36" creationId="{B3997965-390C-48BA-F7D2-3A660ED427DF}"/>
          </ac:spMkLst>
        </pc:spChg>
        <pc:spChg chg="mod topLvl">
          <ac:chgData name="美香 三木" userId="0e1e0125d0a1c367" providerId="LiveId" clId="{3A63F794-839C-4206-B70A-1BB4D7774E64}" dt="2024-08-13T10:17:43.518" v="14" actId="164"/>
          <ac:spMkLst>
            <pc:docMk/>
            <pc:sldMk cId="2905389099" sldId="260"/>
            <ac:spMk id="38" creationId="{8DDE47F2-BC15-E4F9-AC6D-30BFB3795F84}"/>
          </ac:spMkLst>
        </pc:spChg>
        <pc:spChg chg="mod topLvl">
          <ac:chgData name="美香 三木" userId="0e1e0125d0a1c367" providerId="LiveId" clId="{3A63F794-839C-4206-B70A-1BB4D7774E64}" dt="2024-08-13T10:17:43.518" v="14" actId="164"/>
          <ac:spMkLst>
            <pc:docMk/>
            <pc:sldMk cId="2905389099" sldId="260"/>
            <ac:spMk id="40" creationId="{8B53E8FC-D365-0B32-7124-E5E0BE71C686}"/>
          </ac:spMkLst>
        </pc:spChg>
        <pc:spChg chg="mod topLvl">
          <ac:chgData name="美香 三木" userId="0e1e0125d0a1c367" providerId="LiveId" clId="{3A63F794-839C-4206-B70A-1BB4D7774E64}" dt="2024-08-13T10:17:43.518" v="14" actId="164"/>
          <ac:spMkLst>
            <pc:docMk/>
            <pc:sldMk cId="2905389099" sldId="260"/>
            <ac:spMk id="41" creationId="{71827D17-42BA-F41C-8854-1169C5546858}"/>
          </ac:spMkLst>
        </pc:spChg>
        <pc:spChg chg="mod topLvl">
          <ac:chgData name="美香 三木" userId="0e1e0125d0a1c367" providerId="LiveId" clId="{3A63F794-839C-4206-B70A-1BB4D7774E64}" dt="2024-08-13T10:17:43.518" v="14" actId="164"/>
          <ac:spMkLst>
            <pc:docMk/>
            <pc:sldMk cId="2905389099" sldId="260"/>
            <ac:spMk id="42" creationId="{C92D0161-E80F-6040-6D7D-356CF6400530}"/>
          </ac:spMkLst>
        </pc:spChg>
        <pc:spChg chg="mod topLvl">
          <ac:chgData name="美香 三木" userId="0e1e0125d0a1c367" providerId="LiveId" clId="{3A63F794-839C-4206-B70A-1BB4D7774E64}" dt="2024-08-13T10:17:43.518" v="14" actId="164"/>
          <ac:spMkLst>
            <pc:docMk/>
            <pc:sldMk cId="2905389099" sldId="260"/>
            <ac:spMk id="43" creationId="{5A5A0E2F-EAAD-78D1-4BCC-4BFDDE368A78}"/>
          </ac:spMkLst>
        </pc:spChg>
        <pc:spChg chg="mod topLvl">
          <ac:chgData name="美香 三木" userId="0e1e0125d0a1c367" providerId="LiveId" clId="{3A63F794-839C-4206-B70A-1BB4D7774E64}" dt="2024-08-13T10:17:43.518" v="14" actId="164"/>
          <ac:spMkLst>
            <pc:docMk/>
            <pc:sldMk cId="2905389099" sldId="260"/>
            <ac:spMk id="52" creationId="{5FDE8C73-5652-9E18-73C7-0BA6C452D71D}"/>
          </ac:spMkLst>
        </pc:spChg>
        <pc:spChg chg="mod">
          <ac:chgData name="美香 三木" userId="0e1e0125d0a1c367" providerId="LiveId" clId="{3A63F794-839C-4206-B70A-1BB4D7774E64}" dt="2024-08-13T10:13:47.158" v="1" actId="165"/>
          <ac:spMkLst>
            <pc:docMk/>
            <pc:sldMk cId="2905389099" sldId="260"/>
            <ac:spMk id="59" creationId="{FEE6AF2B-AD09-5412-D9C6-7FFE4781522B}"/>
          </ac:spMkLst>
        </pc:spChg>
        <pc:spChg chg="mod">
          <ac:chgData name="美香 三木" userId="0e1e0125d0a1c367" providerId="LiveId" clId="{3A63F794-839C-4206-B70A-1BB4D7774E64}" dt="2024-08-13T10:13:47.158" v="1" actId="165"/>
          <ac:spMkLst>
            <pc:docMk/>
            <pc:sldMk cId="2905389099" sldId="260"/>
            <ac:spMk id="60" creationId="{7A7D8B2F-74CA-DA8B-3A23-C54CA4D4315C}"/>
          </ac:spMkLst>
        </pc:spChg>
        <pc:spChg chg="mod">
          <ac:chgData name="美香 三木" userId="0e1e0125d0a1c367" providerId="LiveId" clId="{3A63F794-839C-4206-B70A-1BB4D7774E64}" dt="2024-08-13T10:13:35.710" v="0" actId="207"/>
          <ac:spMkLst>
            <pc:docMk/>
            <pc:sldMk cId="2905389099" sldId="260"/>
            <ac:spMk id="62" creationId="{0DE2DCA9-CAAB-2422-1B56-0AF57318BFFA}"/>
          </ac:spMkLst>
        </pc:spChg>
        <pc:spChg chg="mod">
          <ac:chgData name="美香 三木" userId="0e1e0125d0a1c367" providerId="LiveId" clId="{3A63F794-839C-4206-B70A-1BB4D7774E64}" dt="2024-08-13T10:13:35.710" v="0" actId="207"/>
          <ac:spMkLst>
            <pc:docMk/>
            <pc:sldMk cId="2905389099" sldId="260"/>
            <ac:spMk id="63" creationId="{A1FCC728-7CB6-2D39-904B-1EFE6C2A0269}"/>
          </ac:spMkLst>
        </pc:spChg>
        <pc:grpChg chg="add mod">
          <ac:chgData name="美香 三木" userId="0e1e0125d0a1c367" providerId="LiveId" clId="{3A63F794-839C-4206-B70A-1BB4D7774E64}" dt="2024-08-13T10:17:43.518" v="14" actId="164"/>
          <ac:grpSpMkLst>
            <pc:docMk/>
            <pc:sldMk cId="2905389099" sldId="260"/>
            <ac:grpSpMk id="5" creationId="{CE3D370A-8208-7C27-79FD-AF0ADFB97AF4}"/>
          </ac:grpSpMkLst>
        </pc:grpChg>
        <pc:grpChg chg="del">
          <ac:chgData name="美香 三木" userId="0e1e0125d0a1c367" providerId="LiveId" clId="{3A63F794-839C-4206-B70A-1BB4D7774E64}" dt="2024-08-13T10:13:47.158" v="1" actId="165"/>
          <ac:grpSpMkLst>
            <pc:docMk/>
            <pc:sldMk cId="2905389099" sldId="260"/>
            <ac:grpSpMk id="12" creationId="{BE2F3987-A2E2-932A-1215-B0380F697437}"/>
          </ac:grpSpMkLst>
        </pc:grpChg>
        <pc:grpChg chg="mod topLvl">
          <ac:chgData name="美香 三木" userId="0e1e0125d0a1c367" providerId="LiveId" clId="{3A63F794-839C-4206-B70A-1BB4D7774E64}" dt="2024-08-13T10:17:43.518" v="14" actId="164"/>
          <ac:grpSpMkLst>
            <pc:docMk/>
            <pc:sldMk cId="2905389099" sldId="260"/>
            <ac:grpSpMk id="39" creationId="{A3014382-C272-25E2-5521-CC86833BB561}"/>
          </ac:grpSpMkLst>
        </pc:grpChg>
        <pc:grpChg chg="mod">
          <ac:chgData name="美香 三木" userId="0e1e0125d0a1c367" providerId="LiveId" clId="{3A63F794-839C-4206-B70A-1BB4D7774E64}" dt="2024-08-13T10:13:35.710" v="0" actId="207"/>
          <ac:grpSpMkLst>
            <pc:docMk/>
            <pc:sldMk cId="2905389099" sldId="260"/>
            <ac:grpSpMk id="61" creationId="{A7340FFC-9191-AE43-D1FA-91B2FB4BCD70}"/>
          </ac:grpSpMkLst>
        </pc:grpChg>
        <pc:cxnChg chg="mod topLvl">
          <ac:chgData name="美香 三木" userId="0e1e0125d0a1c367" providerId="LiveId" clId="{3A63F794-839C-4206-B70A-1BB4D7774E64}" dt="2024-08-13T10:17:43.518" v="14" actId="164"/>
          <ac:cxnSpMkLst>
            <pc:docMk/>
            <pc:sldMk cId="2905389099" sldId="260"/>
            <ac:cxnSpMk id="13" creationId="{5CD483E4-D512-D781-3265-318C1C405351}"/>
          </ac:cxnSpMkLst>
        </pc:cxnChg>
      </pc:sldChg>
    </pc:docChg>
  </pc:docChgLst>
  <pc:docChgLst>
    <pc:chgData name="美香 三木" userId="0e1e0125d0a1c367" providerId="LiveId" clId="{1182BB76-43BB-4781-8331-71C00D22F5B7}"/>
    <pc:docChg chg="undo redo custSel addSld delSld modSld sldOrd">
      <pc:chgData name="美香 三木" userId="0e1e0125d0a1c367" providerId="LiveId" clId="{1182BB76-43BB-4781-8331-71C00D22F5B7}" dt="2023-12-12T01:15:34.398" v="901" actId="14100"/>
      <pc:docMkLst>
        <pc:docMk/>
      </pc:docMkLst>
      <pc:sldChg chg="modSp mod">
        <pc:chgData name="美香 三木" userId="0e1e0125d0a1c367" providerId="LiveId" clId="{1182BB76-43BB-4781-8331-71C00D22F5B7}" dt="2023-11-28T11:45:01.745" v="496" actId="20577"/>
        <pc:sldMkLst>
          <pc:docMk/>
          <pc:sldMk cId="2905389099" sldId="260"/>
        </pc:sldMkLst>
        <pc:spChg chg="mod">
          <ac:chgData name="美香 三木" userId="0e1e0125d0a1c367" providerId="LiveId" clId="{1182BB76-43BB-4781-8331-71C00D22F5B7}" dt="2023-11-28T11:45:01.745" v="496" actId="20577"/>
          <ac:spMkLst>
            <pc:docMk/>
            <pc:sldMk cId="2905389099" sldId="260"/>
            <ac:spMk id="2" creationId="{0D32CA26-8924-CEA5-F45E-B4AB2D121836}"/>
          </ac:spMkLst>
        </pc:spChg>
      </pc:sldChg>
      <pc:sldChg chg="modSp mod">
        <pc:chgData name="美香 三木" userId="0e1e0125d0a1c367" providerId="LiveId" clId="{1182BB76-43BB-4781-8331-71C00D22F5B7}" dt="2023-11-28T09:54:36.426" v="480" actId="1038"/>
        <pc:sldMkLst>
          <pc:docMk/>
          <pc:sldMk cId="3052066375" sldId="286"/>
        </pc:sldMkLst>
        <pc:cxnChg chg="mod">
          <ac:chgData name="美香 三木" userId="0e1e0125d0a1c367" providerId="LiveId" clId="{1182BB76-43BB-4781-8331-71C00D22F5B7}" dt="2023-11-28T09:54:36.426" v="480" actId="1038"/>
          <ac:cxnSpMkLst>
            <pc:docMk/>
            <pc:sldMk cId="3052066375" sldId="286"/>
            <ac:cxnSpMk id="63" creationId="{342C91E4-A32E-C089-D0AA-FB0364B8C33E}"/>
          </ac:cxnSpMkLst>
        </pc:cxnChg>
      </pc:sldChg>
      <pc:sldChg chg="del">
        <pc:chgData name="美香 三木" userId="0e1e0125d0a1c367" providerId="LiveId" clId="{1182BB76-43BB-4781-8331-71C00D22F5B7}" dt="2023-11-24T08:42:17.440" v="312" actId="2696"/>
        <pc:sldMkLst>
          <pc:docMk/>
          <pc:sldMk cId="3333424220" sldId="290"/>
        </pc:sldMkLst>
      </pc:sldChg>
      <pc:sldChg chg="addSp delSp modSp add del mod">
        <pc:chgData name="美香 三木" userId="0e1e0125d0a1c367" providerId="LiveId" clId="{1182BB76-43BB-4781-8331-71C00D22F5B7}" dt="2023-11-28T03:40:58.258" v="477" actId="2696"/>
        <pc:sldMkLst>
          <pc:docMk/>
          <pc:sldMk cId="3893840646" sldId="291"/>
        </pc:sldMkLst>
        <pc:spChg chg="mod">
          <ac:chgData name="美香 三木" userId="0e1e0125d0a1c367" providerId="LiveId" clId="{1182BB76-43BB-4781-8331-71C00D22F5B7}" dt="2023-11-24T08:29:11.011" v="259" actId="1076"/>
          <ac:spMkLst>
            <pc:docMk/>
            <pc:sldMk cId="3893840646" sldId="291"/>
            <ac:spMk id="3" creationId="{BC8356A2-A909-B2A1-4BB6-52A18B7FA04B}"/>
          </ac:spMkLst>
        </pc:spChg>
        <pc:spChg chg="mod">
          <ac:chgData name="美香 三木" userId="0e1e0125d0a1c367" providerId="LiveId" clId="{1182BB76-43BB-4781-8331-71C00D22F5B7}" dt="2023-11-24T08:22:42.927" v="135" actId="1076"/>
          <ac:spMkLst>
            <pc:docMk/>
            <pc:sldMk cId="3893840646" sldId="291"/>
            <ac:spMk id="4" creationId="{E26F9912-356B-7BE8-6123-EFA291DEF59A}"/>
          </ac:spMkLst>
        </pc:spChg>
        <pc:spChg chg="mod">
          <ac:chgData name="美香 三木" userId="0e1e0125d0a1c367" providerId="LiveId" clId="{1182BB76-43BB-4781-8331-71C00D22F5B7}" dt="2023-11-24T08:23:02.350" v="138" actId="1076"/>
          <ac:spMkLst>
            <pc:docMk/>
            <pc:sldMk cId="3893840646" sldId="291"/>
            <ac:spMk id="6" creationId="{8527FFC9-7A28-CA95-4BCE-988424188E74}"/>
          </ac:spMkLst>
        </pc:spChg>
        <pc:spChg chg="mod">
          <ac:chgData name="美香 三木" userId="0e1e0125d0a1c367" providerId="LiveId" clId="{1182BB76-43BB-4781-8331-71C00D22F5B7}" dt="2023-11-24T08:32:31.251" v="311" actId="1038"/>
          <ac:spMkLst>
            <pc:docMk/>
            <pc:sldMk cId="3893840646" sldId="291"/>
            <ac:spMk id="8" creationId="{A6CD0609-DB43-7E4B-3AA2-6DD51E8CA397}"/>
          </ac:spMkLst>
        </pc:spChg>
        <pc:spChg chg="mod ord">
          <ac:chgData name="美香 三木" userId="0e1e0125d0a1c367" providerId="LiveId" clId="{1182BB76-43BB-4781-8331-71C00D22F5B7}" dt="2023-11-24T08:25:30.233" v="197" actId="14100"/>
          <ac:spMkLst>
            <pc:docMk/>
            <pc:sldMk cId="3893840646" sldId="291"/>
            <ac:spMk id="9" creationId="{C85B2E7D-52F7-46B1-DAF9-EAF96CD0F0D5}"/>
          </ac:spMkLst>
        </pc:spChg>
        <pc:spChg chg="mod">
          <ac:chgData name="美香 三木" userId="0e1e0125d0a1c367" providerId="LiveId" clId="{1182BB76-43BB-4781-8331-71C00D22F5B7}" dt="2023-11-24T08:28:59.240" v="257" actId="688"/>
          <ac:spMkLst>
            <pc:docMk/>
            <pc:sldMk cId="3893840646" sldId="291"/>
            <ac:spMk id="13" creationId="{48451593-7EC1-EABB-4BFD-5A0D8BA8B322}"/>
          </ac:spMkLst>
        </pc:spChg>
        <pc:picChg chg="del">
          <ac:chgData name="美香 三木" userId="0e1e0125d0a1c367" providerId="LiveId" clId="{1182BB76-43BB-4781-8331-71C00D22F5B7}" dt="2023-11-24T08:14:57.816" v="1" actId="478"/>
          <ac:picMkLst>
            <pc:docMk/>
            <pc:sldMk cId="3893840646" sldId="291"/>
            <ac:picMk id="5" creationId="{DE74B4D5-688B-18E9-DA6C-8C6E31D1B6ED}"/>
          </ac:picMkLst>
        </pc:picChg>
        <pc:picChg chg="del">
          <ac:chgData name="美香 三木" userId="0e1e0125d0a1c367" providerId="LiveId" clId="{1182BB76-43BB-4781-8331-71C00D22F5B7}" dt="2023-11-24T08:14:59.594" v="2" actId="478"/>
          <ac:picMkLst>
            <pc:docMk/>
            <pc:sldMk cId="3893840646" sldId="291"/>
            <ac:picMk id="7" creationId="{B87A991C-33B6-64AC-8A39-E357A41FE912}"/>
          </ac:picMkLst>
        </pc:picChg>
        <pc:picChg chg="add del mod ord modCrop">
          <ac:chgData name="美香 三木" userId="0e1e0125d0a1c367" providerId="LiveId" clId="{1182BB76-43BB-4781-8331-71C00D22F5B7}" dt="2023-11-24T08:26:23.042" v="200" actId="1076"/>
          <ac:picMkLst>
            <pc:docMk/>
            <pc:sldMk cId="3893840646" sldId="291"/>
            <ac:picMk id="11" creationId="{387E26FE-FBEB-2E18-310A-3456CECC5BF4}"/>
          </ac:picMkLst>
        </pc:picChg>
        <pc:picChg chg="add del mod">
          <ac:chgData name="美香 三木" userId="0e1e0125d0a1c367" providerId="LiveId" clId="{1182BB76-43BB-4781-8331-71C00D22F5B7}" dt="2023-11-24T08:17:03.868" v="39" actId="931"/>
          <ac:picMkLst>
            <pc:docMk/>
            <pc:sldMk cId="3893840646" sldId="291"/>
            <ac:picMk id="14" creationId="{30E118C0-885D-60EF-EA1C-183A7CB876A4}"/>
          </ac:picMkLst>
        </pc:picChg>
        <pc:picChg chg="del">
          <ac:chgData name="美香 三木" userId="0e1e0125d0a1c367" providerId="LiveId" clId="{1182BB76-43BB-4781-8331-71C00D22F5B7}" dt="2023-11-24T08:15:03.582" v="4" actId="478"/>
          <ac:picMkLst>
            <pc:docMk/>
            <pc:sldMk cId="3893840646" sldId="291"/>
            <ac:picMk id="15" creationId="{532F319C-7ED3-328B-6F7F-30A890FA7CFD}"/>
          </ac:picMkLst>
        </pc:picChg>
        <pc:picChg chg="add mod ord modCrop">
          <ac:chgData name="美香 三木" userId="0e1e0125d0a1c367" providerId="LiveId" clId="{1182BB76-43BB-4781-8331-71C00D22F5B7}" dt="2023-11-24T08:30:56.632" v="270" actId="1076"/>
          <ac:picMkLst>
            <pc:docMk/>
            <pc:sldMk cId="3893840646" sldId="291"/>
            <ac:picMk id="17" creationId="{0D89065C-4DB5-AD54-BE57-0658F89FFCA3}"/>
          </ac:picMkLst>
        </pc:picChg>
        <pc:picChg chg="del">
          <ac:chgData name="美香 三木" userId="0e1e0125d0a1c367" providerId="LiveId" clId="{1182BB76-43BB-4781-8331-71C00D22F5B7}" dt="2023-11-24T08:15:01.644" v="3" actId="478"/>
          <ac:picMkLst>
            <pc:docMk/>
            <pc:sldMk cId="3893840646" sldId="291"/>
            <ac:picMk id="19" creationId="{6A96C14B-2F64-A866-3E8A-EDE331E719F0}"/>
          </ac:picMkLst>
        </pc:picChg>
        <pc:picChg chg="add mod">
          <ac:chgData name="美香 三木" userId="0e1e0125d0a1c367" providerId="LiveId" clId="{1182BB76-43BB-4781-8331-71C00D22F5B7}" dt="2023-11-24T08:27:58.949" v="240" actId="1582"/>
          <ac:picMkLst>
            <pc:docMk/>
            <pc:sldMk cId="3893840646" sldId="291"/>
            <ac:picMk id="20" creationId="{E354674E-D47F-09B2-FCF5-297C021D6342}"/>
          </ac:picMkLst>
        </pc:picChg>
        <pc:picChg chg="add mod ord">
          <ac:chgData name="美香 三木" userId="0e1e0125d0a1c367" providerId="LiveId" clId="{1182BB76-43BB-4781-8331-71C00D22F5B7}" dt="2023-11-24T08:29:39.148" v="264" actId="1076"/>
          <ac:picMkLst>
            <pc:docMk/>
            <pc:sldMk cId="3893840646" sldId="291"/>
            <ac:picMk id="22" creationId="{60067DE7-1A0F-741F-853F-4FC7A0C24F92}"/>
          </ac:picMkLst>
        </pc:picChg>
      </pc:sldChg>
      <pc:sldChg chg="addSp delSp modSp add del mod ord">
        <pc:chgData name="美香 三木" userId="0e1e0125d0a1c367" providerId="LiveId" clId="{1182BB76-43BB-4781-8331-71C00D22F5B7}" dt="2023-12-12T01:15:19.912" v="900" actId="2696"/>
        <pc:sldMkLst>
          <pc:docMk/>
          <pc:sldMk cId="1616645417" sldId="292"/>
        </pc:sldMkLst>
        <pc:spChg chg="mod">
          <ac:chgData name="美香 三木" userId="0e1e0125d0a1c367" providerId="LiveId" clId="{1182BB76-43BB-4781-8331-71C00D22F5B7}" dt="2023-12-05T01:23:45.576" v="497" actId="14100"/>
          <ac:spMkLst>
            <pc:docMk/>
            <pc:sldMk cId="1616645417" sldId="292"/>
            <ac:spMk id="8" creationId="{A6CD0609-DB43-7E4B-3AA2-6DD51E8CA397}"/>
          </ac:spMkLst>
        </pc:spChg>
        <pc:spChg chg="mod">
          <ac:chgData name="美香 三木" userId="0e1e0125d0a1c367" providerId="LiveId" clId="{1182BB76-43BB-4781-8331-71C00D22F5B7}" dt="2023-12-08T08:14:35.221" v="500" actId="1582"/>
          <ac:spMkLst>
            <pc:docMk/>
            <pc:sldMk cId="1616645417" sldId="292"/>
            <ac:spMk id="9" creationId="{C85B2E7D-52F7-46B1-DAF9-EAF96CD0F0D5}"/>
          </ac:spMkLst>
        </pc:spChg>
        <pc:spChg chg="mod">
          <ac:chgData name="美香 三木" userId="0e1e0125d0a1c367" providerId="LiveId" clId="{1182BB76-43BB-4781-8331-71C00D22F5B7}" dt="2023-11-28T11:44:54.981" v="492" actId="20577"/>
          <ac:spMkLst>
            <pc:docMk/>
            <pc:sldMk cId="1616645417" sldId="292"/>
            <ac:spMk id="10" creationId="{6021388C-E702-CA7E-11A7-1DA0BFCE0770}"/>
          </ac:spMkLst>
        </pc:spChg>
        <pc:picChg chg="add mod ord modCrop">
          <ac:chgData name="美香 三木" userId="0e1e0125d0a1c367" providerId="LiveId" clId="{1182BB76-43BB-4781-8331-71C00D22F5B7}" dt="2023-11-28T03:33:34.492" v="473" actId="1076"/>
          <ac:picMkLst>
            <pc:docMk/>
            <pc:sldMk cId="1616645417" sldId="292"/>
            <ac:picMk id="5" creationId="{DB8AE7F7-0248-712F-31A2-1B96CDB54504}"/>
          </ac:picMkLst>
        </pc:picChg>
        <pc:picChg chg="del">
          <ac:chgData name="美香 三木" userId="0e1e0125d0a1c367" providerId="LiveId" clId="{1182BB76-43BB-4781-8331-71C00D22F5B7}" dt="2023-11-28T03:26:20.475" v="314" actId="478"/>
          <ac:picMkLst>
            <pc:docMk/>
            <pc:sldMk cId="1616645417" sldId="292"/>
            <ac:picMk id="11" creationId="{387E26FE-FBEB-2E18-310A-3456CECC5BF4}"/>
          </ac:picMkLst>
        </pc:picChg>
        <pc:picChg chg="add mod ord">
          <ac:chgData name="美香 三木" userId="0e1e0125d0a1c367" providerId="LiveId" clId="{1182BB76-43BB-4781-8331-71C00D22F5B7}" dt="2023-11-28T03:33:57.444" v="476" actId="1582"/>
          <ac:picMkLst>
            <pc:docMk/>
            <pc:sldMk cId="1616645417" sldId="292"/>
            <ac:picMk id="12" creationId="{7EC7DDA0-0358-B2A2-0DA0-703F74FC7949}"/>
          </ac:picMkLst>
        </pc:picChg>
        <pc:picChg chg="del">
          <ac:chgData name="美香 三木" userId="0e1e0125d0a1c367" providerId="LiveId" clId="{1182BB76-43BB-4781-8331-71C00D22F5B7}" dt="2023-11-28T03:26:22.525" v="315" actId="478"/>
          <ac:picMkLst>
            <pc:docMk/>
            <pc:sldMk cId="1616645417" sldId="292"/>
            <ac:picMk id="20" creationId="{E354674E-D47F-09B2-FCF5-297C021D6342}"/>
          </ac:picMkLst>
        </pc:picChg>
      </pc:sldChg>
      <pc:sldChg chg="addSp delSp modSp add del mod">
        <pc:chgData name="美香 三木" userId="0e1e0125d0a1c367" providerId="LiveId" clId="{1182BB76-43BB-4781-8331-71C00D22F5B7}" dt="2023-11-28T11:33:41.641" v="481" actId="2696"/>
        <pc:sldMkLst>
          <pc:docMk/>
          <pc:sldMk cId="3056164484" sldId="293"/>
        </pc:sldMkLst>
        <pc:spChg chg="mod">
          <ac:chgData name="美香 三木" userId="0e1e0125d0a1c367" providerId="LiveId" clId="{1182BB76-43BB-4781-8331-71C00D22F5B7}" dt="2023-11-28T03:32:58.240" v="469" actId="1038"/>
          <ac:spMkLst>
            <pc:docMk/>
            <pc:sldMk cId="3056164484" sldId="293"/>
            <ac:spMk id="9" creationId="{C85B2E7D-52F7-46B1-DAF9-EAF96CD0F0D5}"/>
          </ac:spMkLst>
        </pc:spChg>
        <pc:picChg chg="del">
          <ac:chgData name="美香 三木" userId="0e1e0125d0a1c367" providerId="LiveId" clId="{1182BB76-43BB-4781-8331-71C00D22F5B7}" dt="2023-11-28T03:29:49.769" v="391" actId="478"/>
          <ac:picMkLst>
            <pc:docMk/>
            <pc:sldMk cId="3056164484" sldId="293"/>
            <ac:picMk id="5" creationId="{DB8AE7F7-0248-712F-31A2-1B96CDB54504}"/>
          </ac:picMkLst>
        </pc:picChg>
        <pc:picChg chg="add mod ord modCrop">
          <ac:chgData name="美香 三木" userId="0e1e0125d0a1c367" providerId="LiveId" clId="{1182BB76-43BB-4781-8331-71C00D22F5B7}" dt="2023-11-28T03:31:23.806" v="428" actId="1076"/>
          <ac:picMkLst>
            <pc:docMk/>
            <pc:sldMk cId="3056164484" sldId="293"/>
            <ac:picMk id="7" creationId="{21D7FB5A-6885-FAD0-FBEF-B916E3C8D28B}"/>
          </ac:picMkLst>
        </pc:picChg>
        <pc:picChg chg="del">
          <ac:chgData name="美香 三木" userId="0e1e0125d0a1c367" providerId="LiveId" clId="{1182BB76-43BB-4781-8331-71C00D22F5B7}" dt="2023-11-28T03:29:46.846" v="390" actId="478"/>
          <ac:picMkLst>
            <pc:docMk/>
            <pc:sldMk cId="3056164484" sldId="293"/>
            <ac:picMk id="12" creationId="{7EC7DDA0-0358-B2A2-0DA0-703F74FC7949}"/>
          </ac:picMkLst>
        </pc:picChg>
        <pc:picChg chg="add mod">
          <ac:chgData name="美香 三木" userId="0e1e0125d0a1c367" providerId="LiveId" clId="{1182BB76-43BB-4781-8331-71C00D22F5B7}" dt="2023-11-28T03:31:57.239" v="460" actId="1582"/>
          <ac:picMkLst>
            <pc:docMk/>
            <pc:sldMk cId="3056164484" sldId="293"/>
            <ac:picMk id="14" creationId="{ADE58E53-A9BD-025F-B69C-69655A667325}"/>
          </ac:picMkLst>
        </pc:picChg>
      </pc:sldChg>
      <pc:sldChg chg="addSp modSp add mod">
        <pc:chgData name="美香 三木" userId="0e1e0125d0a1c367" providerId="LiveId" clId="{1182BB76-43BB-4781-8331-71C00D22F5B7}" dt="2023-12-12T01:15:34.398" v="901" actId="14100"/>
        <pc:sldMkLst>
          <pc:docMk/>
          <pc:sldMk cId="3651008496" sldId="293"/>
        </pc:sldMkLst>
        <pc:spChg chg="mod">
          <ac:chgData name="美香 三木" userId="0e1e0125d0a1c367" providerId="LiveId" clId="{1182BB76-43BB-4781-8331-71C00D22F5B7}" dt="2023-12-08T09:03:34.478" v="890" actId="1038"/>
          <ac:spMkLst>
            <pc:docMk/>
            <pc:sldMk cId="3651008496" sldId="293"/>
            <ac:spMk id="3" creationId="{BC8356A2-A909-B2A1-4BB6-52A18B7FA04B}"/>
          </ac:spMkLst>
        </pc:spChg>
        <pc:spChg chg="mod">
          <ac:chgData name="美香 三木" userId="0e1e0125d0a1c367" providerId="LiveId" clId="{1182BB76-43BB-4781-8331-71C00D22F5B7}" dt="2023-12-08T09:05:34.260" v="898" actId="1076"/>
          <ac:spMkLst>
            <pc:docMk/>
            <pc:sldMk cId="3651008496" sldId="293"/>
            <ac:spMk id="4" creationId="{E26F9912-356B-7BE8-6123-EFA291DEF59A}"/>
          </ac:spMkLst>
        </pc:spChg>
        <pc:spChg chg="mod">
          <ac:chgData name="美香 三木" userId="0e1e0125d0a1c367" providerId="LiveId" clId="{1182BB76-43BB-4781-8331-71C00D22F5B7}" dt="2023-12-08T09:08:24.601" v="899" actId="1076"/>
          <ac:spMkLst>
            <pc:docMk/>
            <pc:sldMk cId="3651008496" sldId="293"/>
            <ac:spMk id="6" creationId="{8527FFC9-7A28-CA95-4BCE-988424188E74}"/>
          </ac:spMkLst>
        </pc:spChg>
        <pc:spChg chg="mod">
          <ac:chgData name="美香 三木" userId="0e1e0125d0a1c367" providerId="LiveId" clId="{1182BB76-43BB-4781-8331-71C00D22F5B7}" dt="2023-12-08T09:03:34.478" v="890" actId="1038"/>
          <ac:spMkLst>
            <pc:docMk/>
            <pc:sldMk cId="3651008496" sldId="293"/>
            <ac:spMk id="8" creationId="{A6CD0609-DB43-7E4B-3AA2-6DD51E8CA397}"/>
          </ac:spMkLst>
        </pc:spChg>
        <pc:spChg chg="mod">
          <ac:chgData name="美香 三木" userId="0e1e0125d0a1c367" providerId="LiveId" clId="{1182BB76-43BB-4781-8331-71C00D22F5B7}" dt="2023-12-08T09:04:22.566" v="894" actId="1076"/>
          <ac:spMkLst>
            <pc:docMk/>
            <pc:sldMk cId="3651008496" sldId="293"/>
            <ac:spMk id="9" creationId="{C85B2E7D-52F7-46B1-DAF9-EAF96CD0F0D5}"/>
          </ac:spMkLst>
        </pc:spChg>
        <pc:spChg chg="mod">
          <ac:chgData name="美香 三木" userId="0e1e0125d0a1c367" providerId="LiveId" clId="{1182BB76-43BB-4781-8331-71C00D22F5B7}" dt="2023-12-08T09:03:34.478" v="890" actId="1038"/>
          <ac:spMkLst>
            <pc:docMk/>
            <pc:sldMk cId="3651008496" sldId="293"/>
            <ac:spMk id="13" creationId="{48451593-7EC1-EABB-4BFD-5A0D8BA8B322}"/>
          </ac:spMkLst>
        </pc:spChg>
        <pc:picChg chg="mod modCrop">
          <ac:chgData name="美香 三木" userId="0e1e0125d0a1c367" providerId="LiveId" clId="{1182BB76-43BB-4781-8331-71C00D22F5B7}" dt="2023-12-08T09:01:03.991" v="827" actId="1076"/>
          <ac:picMkLst>
            <pc:docMk/>
            <pc:sldMk cId="3651008496" sldId="293"/>
            <ac:picMk id="5" creationId="{DB8AE7F7-0248-712F-31A2-1B96CDB54504}"/>
          </ac:picMkLst>
        </pc:picChg>
        <pc:picChg chg="mod ord">
          <ac:chgData name="美香 三木" userId="0e1e0125d0a1c367" providerId="LiveId" clId="{1182BB76-43BB-4781-8331-71C00D22F5B7}" dt="2023-12-08T09:00:19.482" v="824" actId="1038"/>
          <ac:picMkLst>
            <pc:docMk/>
            <pc:sldMk cId="3651008496" sldId="293"/>
            <ac:picMk id="12" creationId="{7EC7DDA0-0358-B2A2-0DA0-703F74FC7949}"/>
          </ac:picMkLst>
        </pc:picChg>
        <pc:picChg chg="mod modCrop">
          <ac:chgData name="美香 三木" userId="0e1e0125d0a1c367" providerId="LiveId" clId="{1182BB76-43BB-4781-8331-71C00D22F5B7}" dt="2023-12-08T09:03:34.478" v="890" actId="1038"/>
          <ac:picMkLst>
            <pc:docMk/>
            <pc:sldMk cId="3651008496" sldId="293"/>
            <ac:picMk id="17" creationId="{0D89065C-4DB5-AD54-BE57-0658F89FFCA3}"/>
          </ac:picMkLst>
        </pc:picChg>
        <pc:picChg chg="mod ord">
          <ac:chgData name="美香 三木" userId="0e1e0125d0a1c367" providerId="LiveId" clId="{1182BB76-43BB-4781-8331-71C00D22F5B7}" dt="2023-12-08T09:03:34.478" v="890" actId="1038"/>
          <ac:picMkLst>
            <pc:docMk/>
            <pc:sldMk cId="3651008496" sldId="293"/>
            <ac:picMk id="22" creationId="{60067DE7-1A0F-741F-853F-4FC7A0C24F92}"/>
          </ac:picMkLst>
        </pc:picChg>
        <pc:cxnChg chg="add mod">
          <ac:chgData name="美香 三木" userId="0e1e0125d0a1c367" providerId="LiveId" clId="{1182BB76-43BB-4781-8331-71C00D22F5B7}" dt="2023-12-12T01:15:34.398" v="901" actId="14100"/>
          <ac:cxnSpMkLst>
            <pc:docMk/>
            <pc:sldMk cId="3651008496" sldId="293"/>
            <ac:cxnSpMk id="7" creationId="{43008733-A0A7-3485-E88B-C306E1EE032D}"/>
          </ac:cxnSpMkLst>
        </pc:cxnChg>
        <pc:cxnChg chg="add mod">
          <ac:chgData name="美香 三木" userId="0e1e0125d0a1c367" providerId="LiveId" clId="{1182BB76-43BB-4781-8331-71C00D22F5B7}" dt="2023-12-08T09:04:42.212" v="897" actId="14100"/>
          <ac:cxnSpMkLst>
            <pc:docMk/>
            <pc:sldMk cId="3651008496" sldId="293"/>
            <ac:cxnSpMk id="14" creationId="{6284DCA0-03EC-74C7-72B2-81A9894A1E12}"/>
          </ac:cxnSpMkLst>
        </pc:cxnChg>
        <pc:cxnChg chg="add mod">
          <ac:chgData name="美香 三木" userId="0e1e0125d0a1c367" providerId="LiveId" clId="{1182BB76-43BB-4781-8331-71C00D22F5B7}" dt="2023-12-08T09:03:34.478" v="890" actId="1038"/>
          <ac:cxnSpMkLst>
            <pc:docMk/>
            <pc:sldMk cId="3651008496" sldId="293"/>
            <ac:cxnSpMk id="21" creationId="{60CB5BFB-12B3-131D-D7E0-93ED90F24CB2}"/>
          </ac:cxnSpMkLst>
        </pc:cxnChg>
        <pc:cxnChg chg="add mod">
          <ac:chgData name="美香 三木" userId="0e1e0125d0a1c367" providerId="LiveId" clId="{1182BB76-43BB-4781-8331-71C00D22F5B7}" dt="2023-12-08T09:03:34.478" v="890" actId="1038"/>
          <ac:cxnSpMkLst>
            <pc:docMk/>
            <pc:sldMk cId="3651008496" sldId="293"/>
            <ac:cxnSpMk id="29" creationId="{A17C2B5A-8897-1387-5735-1E6CF69E3BBF}"/>
          </ac:cxnSpMkLst>
        </pc:cxnChg>
      </pc:sldChg>
    </pc:docChg>
  </pc:docChgLst>
  <pc:docChgLst>
    <pc:chgData name="美香 三木" userId="0e1e0125d0a1c367" providerId="LiveId" clId="{916A0FC9-5657-41CB-9C48-09E8D18DA186}"/>
    <pc:docChg chg="delSld">
      <pc:chgData name="美香 三木" userId="0e1e0125d0a1c367" providerId="LiveId" clId="{916A0FC9-5657-41CB-9C48-09E8D18DA186}" dt="2024-02-07T02:00:33.896" v="4" actId="47"/>
      <pc:docMkLst>
        <pc:docMk/>
      </pc:docMkLst>
      <pc:sldChg chg="del">
        <pc:chgData name="美香 三木" userId="0e1e0125d0a1c367" providerId="LiveId" clId="{916A0FC9-5657-41CB-9C48-09E8D18DA186}" dt="2024-02-07T02:00:27.851" v="1" actId="47"/>
        <pc:sldMkLst>
          <pc:docMk/>
          <pc:sldMk cId="107991992" sldId="271"/>
        </pc:sldMkLst>
      </pc:sldChg>
      <pc:sldChg chg="del">
        <pc:chgData name="美香 三木" userId="0e1e0125d0a1c367" providerId="LiveId" clId="{916A0FC9-5657-41CB-9C48-09E8D18DA186}" dt="2024-02-07T02:00:26.843" v="0" actId="47"/>
        <pc:sldMkLst>
          <pc:docMk/>
          <pc:sldMk cId="2221402208" sldId="272"/>
        </pc:sldMkLst>
      </pc:sldChg>
      <pc:sldChg chg="del">
        <pc:chgData name="美香 三木" userId="0e1e0125d0a1c367" providerId="LiveId" clId="{916A0FC9-5657-41CB-9C48-09E8D18DA186}" dt="2024-02-07T02:00:31.175" v="3" actId="47"/>
        <pc:sldMkLst>
          <pc:docMk/>
          <pc:sldMk cId="3052066375" sldId="286"/>
        </pc:sldMkLst>
      </pc:sldChg>
      <pc:sldChg chg="del">
        <pc:chgData name="美香 三木" userId="0e1e0125d0a1c367" providerId="LiveId" clId="{916A0FC9-5657-41CB-9C48-09E8D18DA186}" dt="2024-02-07T02:00:33.896" v="4" actId="47"/>
        <pc:sldMkLst>
          <pc:docMk/>
          <pc:sldMk cId="3194587215" sldId="287"/>
        </pc:sldMkLst>
      </pc:sldChg>
      <pc:sldChg chg="del">
        <pc:chgData name="美香 三木" userId="0e1e0125d0a1c367" providerId="LiveId" clId="{916A0FC9-5657-41CB-9C48-09E8D18DA186}" dt="2024-02-07T02:00:30.221" v="2" actId="47"/>
        <pc:sldMkLst>
          <pc:docMk/>
          <pc:sldMk cId="3264128091" sldId="288"/>
        </pc:sldMkLst>
      </pc:sldChg>
    </pc:docChg>
  </pc:docChgLst>
  <pc:docChgLst>
    <pc:chgData name="美香 三木" userId="0e1e0125d0a1c367" providerId="LiveId" clId="{361E59D8-3ECF-4E08-8751-2EACD331B3A2}"/>
    <pc:docChg chg="undo custSel addSld delSld modSld">
      <pc:chgData name="美香 三木" userId="0e1e0125d0a1c367" providerId="LiveId" clId="{361E59D8-3ECF-4E08-8751-2EACD331B3A2}" dt="2024-07-03T01:56:41.903" v="173" actId="2696"/>
      <pc:docMkLst>
        <pc:docMk/>
      </pc:docMkLst>
      <pc:sldChg chg="addSp modSp add del mod">
        <pc:chgData name="美香 三木" userId="0e1e0125d0a1c367" providerId="LiveId" clId="{361E59D8-3ECF-4E08-8751-2EACD331B3A2}" dt="2024-07-03T01:56:41.903" v="173" actId="2696"/>
        <pc:sldMkLst>
          <pc:docMk/>
          <pc:sldMk cId="3254525387" sldId="261"/>
        </pc:sldMkLst>
        <pc:spChg chg="add mod">
          <ac:chgData name="美香 三木" userId="0e1e0125d0a1c367" providerId="LiveId" clId="{361E59D8-3ECF-4E08-8751-2EACD331B3A2}" dt="2024-07-03T01:55:29.634" v="167" actId="1076"/>
          <ac:spMkLst>
            <pc:docMk/>
            <pc:sldMk cId="3254525387" sldId="261"/>
            <ac:spMk id="5" creationId="{EAF83C4F-B700-69B8-75C5-5C03752F8BFD}"/>
          </ac:spMkLst>
        </pc:spChg>
        <pc:spChg chg="mod">
          <ac:chgData name="美香 三木" userId="0e1e0125d0a1c367" providerId="LiveId" clId="{361E59D8-3ECF-4E08-8751-2EACD331B3A2}" dt="2024-07-03T01:52:27.461" v="30" actId="1038"/>
          <ac:spMkLst>
            <pc:docMk/>
            <pc:sldMk cId="3254525387" sldId="261"/>
            <ac:spMk id="45" creationId="{A4E1EC35-C59E-00A5-6AC5-3D18F1DA8C93}"/>
          </ac:spMkLst>
        </pc:spChg>
        <pc:spChg chg="mod">
          <ac:chgData name="美香 三木" userId="0e1e0125d0a1c367" providerId="LiveId" clId="{361E59D8-3ECF-4E08-8751-2EACD331B3A2}" dt="2024-07-03T01:52:27.461" v="30" actId="1038"/>
          <ac:spMkLst>
            <pc:docMk/>
            <pc:sldMk cId="3254525387" sldId="261"/>
            <ac:spMk id="46" creationId="{A0650309-47D8-6BE7-A83B-B007B4983A38}"/>
          </ac:spMkLst>
        </pc:spChg>
        <pc:spChg chg="mod">
          <ac:chgData name="美香 三木" userId="0e1e0125d0a1c367" providerId="LiveId" clId="{361E59D8-3ECF-4E08-8751-2EACD331B3A2}" dt="2024-07-03T01:52:27.461" v="30" actId="1038"/>
          <ac:spMkLst>
            <pc:docMk/>
            <pc:sldMk cId="3254525387" sldId="261"/>
            <ac:spMk id="47" creationId="{B82AB033-2103-CEC6-D43E-604C4160308B}"/>
          </ac:spMkLst>
        </pc:spChg>
        <pc:spChg chg="mod">
          <ac:chgData name="美香 三木" userId="0e1e0125d0a1c367" providerId="LiveId" clId="{361E59D8-3ECF-4E08-8751-2EACD331B3A2}" dt="2024-07-03T01:52:27.461" v="30" actId="1038"/>
          <ac:spMkLst>
            <pc:docMk/>
            <pc:sldMk cId="3254525387" sldId="261"/>
            <ac:spMk id="49" creationId="{0AEF9CA2-87A0-C4A4-051B-6E85023C5868}"/>
          </ac:spMkLst>
        </pc:spChg>
        <pc:spChg chg="mod">
          <ac:chgData name="美香 三木" userId="0e1e0125d0a1c367" providerId="LiveId" clId="{361E59D8-3ECF-4E08-8751-2EACD331B3A2}" dt="2024-07-03T01:52:27.461" v="30" actId="1038"/>
          <ac:spMkLst>
            <pc:docMk/>
            <pc:sldMk cId="3254525387" sldId="261"/>
            <ac:spMk id="53" creationId="{E1858B8B-34E0-7FBE-133B-E3FCC9A06306}"/>
          </ac:spMkLst>
        </pc:spChg>
        <pc:spChg chg="mod">
          <ac:chgData name="美香 三木" userId="0e1e0125d0a1c367" providerId="LiveId" clId="{361E59D8-3ECF-4E08-8751-2EACD331B3A2}" dt="2024-07-03T01:52:27.461" v="30" actId="1038"/>
          <ac:spMkLst>
            <pc:docMk/>
            <pc:sldMk cId="3254525387" sldId="261"/>
            <ac:spMk id="54" creationId="{BF06C7FC-2753-0053-4EC6-469B68CA343E}"/>
          </ac:spMkLst>
        </pc:spChg>
        <pc:spChg chg="mod">
          <ac:chgData name="美香 三木" userId="0e1e0125d0a1c367" providerId="LiveId" clId="{361E59D8-3ECF-4E08-8751-2EACD331B3A2}" dt="2024-07-03T01:56:18.440" v="170" actId="1076"/>
          <ac:spMkLst>
            <pc:docMk/>
            <pc:sldMk cId="3254525387" sldId="261"/>
            <ac:spMk id="67" creationId="{F63172CC-3A7A-AC85-1EE5-0ADDFE27CEAC}"/>
          </ac:spMkLst>
        </pc:spChg>
        <pc:grpChg chg="mod">
          <ac:chgData name="美香 三木" userId="0e1e0125d0a1c367" providerId="LiveId" clId="{361E59D8-3ECF-4E08-8751-2EACD331B3A2}" dt="2024-07-03T01:52:27.461" v="30" actId="1038"/>
          <ac:grpSpMkLst>
            <pc:docMk/>
            <pc:sldMk cId="3254525387" sldId="261"/>
            <ac:grpSpMk id="61" creationId="{A7340FFC-9191-AE43-D1FA-91B2FB4BCD70}"/>
          </ac:grpSpMkLst>
        </pc:grpChg>
        <pc:cxnChg chg="mod">
          <ac:chgData name="美香 三木" userId="0e1e0125d0a1c367" providerId="LiveId" clId="{361E59D8-3ECF-4E08-8751-2EACD331B3A2}" dt="2024-07-03T01:52:27.461" v="30" actId="1038"/>
          <ac:cxnSpMkLst>
            <pc:docMk/>
            <pc:sldMk cId="3254525387" sldId="261"/>
            <ac:cxnSpMk id="48" creationId="{2E0A115A-6D5D-F07C-60DF-E14BC0CA39AF}"/>
          </ac:cxnSpMkLst>
        </pc:cxnChg>
      </pc:sldChg>
      <pc:sldChg chg="add del">
        <pc:chgData name="美香 三木" userId="0e1e0125d0a1c367" providerId="LiveId" clId="{361E59D8-3ECF-4E08-8751-2EACD331B3A2}" dt="2024-07-03T01:56:39.590" v="172" actId="2696"/>
        <pc:sldMkLst>
          <pc:docMk/>
          <pc:sldMk cId="3865488741" sldId="262"/>
        </pc:sldMkLst>
      </pc:sldChg>
    </pc:docChg>
  </pc:docChgLst>
  <pc:docChgLst>
    <pc:chgData name="美香 三木" userId="0e1e0125d0a1c367" providerId="LiveId" clId="{A5F75A57-72E0-4DB5-97A5-136CE3BC0AB1}"/>
    <pc:docChg chg="undo custSel modSld">
      <pc:chgData name="美香 三木" userId="0e1e0125d0a1c367" providerId="LiveId" clId="{A5F75A57-72E0-4DB5-97A5-136CE3BC0AB1}" dt="2024-05-24T08:23:28.699" v="168" actId="12789"/>
      <pc:docMkLst>
        <pc:docMk/>
      </pc:docMkLst>
      <pc:sldChg chg="addSp delSp modSp mod">
        <pc:chgData name="美香 三木" userId="0e1e0125d0a1c367" providerId="LiveId" clId="{A5F75A57-72E0-4DB5-97A5-136CE3BC0AB1}" dt="2024-05-24T08:23:28.699" v="168" actId="12789"/>
        <pc:sldMkLst>
          <pc:docMk/>
          <pc:sldMk cId="2905389099" sldId="260"/>
        </pc:sldMkLst>
        <pc:spChg chg="mod">
          <ac:chgData name="美香 三木" userId="0e1e0125d0a1c367" providerId="LiveId" clId="{A5F75A57-72E0-4DB5-97A5-136CE3BC0AB1}" dt="2024-05-24T08:17:38.569" v="34" actId="554"/>
          <ac:spMkLst>
            <pc:docMk/>
            <pc:sldMk cId="2905389099" sldId="260"/>
            <ac:spMk id="15" creationId="{00993567-9894-B5E6-ECDE-193A28F51F3C}"/>
          </ac:spMkLst>
        </pc:spChg>
        <pc:spChg chg="mod">
          <ac:chgData name="美香 三木" userId="0e1e0125d0a1c367" providerId="LiveId" clId="{A5F75A57-72E0-4DB5-97A5-136CE3BC0AB1}" dt="2024-05-24T08:08:07.910" v="0"/>
          <ac:spMkLst>
            <pc:docMk/>
            <pc:sldMk cId="2905389099" sldId="260"/>
            <ac:spMk id="18" creationId="{B0422F8D-E6AF-2D70-A20D-C06663B8D11B}"/>
          </ac:spMkLst>
        </pc:spChg>
        <pc:spChg chg="del">
          <ac:chgData name="美香 三木" userId="0e1e0125d0a1c367" providerId="LiveId" clId="{A5F75A57-72E0-4DB5-97A5-136CE3BC0AB1}" dt="2024-05-24T08:08:18.771" v="2" actId="478"/>
          <ac:spMkLst>
            <pc:docMk/>
            <pc:sldMk cId="2905389099" sldId="260"/>
            <ac:spMk id="29" creationId="{B9113293-72E8-7D11-71E7-A6E6284ED874}"/>
          </ac:spMkLst>
        </pc:spChg>
        <pc:spChg chg="del">
          <ac:chgData name="美香 三木" userId="0e1e0125d0a1c367" providerId="LiveId" clId="{A5F75A57-72E0-4DB5-97A5-136CE3BC0AB1}" dt="2024-05-24T08:08:18.771" v="2" actId="478"/>
          <ac:spMkLst>
            <pc:docMk/>
            <pc:sldMk cId="2905389099" sldId="260"/>
            <ac:spMk id="32" creationId="{34A3033A-4F17-D4C1-7016-EF9192DCAB31}"/>
          </ac:spMkLst>
        </pc:spChg>
        <pc:spChg chg="del">
          <ac:chgData name="美香 三木" userId="0e1e0125d0a1c367" providerId="LiveId" clId="{A5F75A57-72E0-4DB5-97A5-136CE3BC0AB1}" dt="2024-05-24T08:08:18.771" v="2" actId="478"/>
          <ac:spMkLst>
            <pc:docMk/>
            <pc:sldMk cId="2905389099" sldId="260"/>
            <ac:spMk id="33" creationId="{E8FB8178-BB7B-79E7-BCD9-9F42591BA6E7}"/>
          </ac:spMkLst>
        </pc:spChg>
        <pc:spChg chg="mod">
          <ac:chgData name="美香 三木" userId="0e1e0125d0a1c367" providerId="LiveId" clId="{A5F75A57-72E0-4DB5-97A5-136CE3BC0AB1}" dt="2024-05-24T08:08:07.910" v="0"/>
          <ac:spMkLst>
            <pc:docMk/>
            <pc:sldMk cId="2905389099" sldId="260"/>
            <ac:spMk id="34" creationId="{CED823C8-B7CB-7495-92A9-CC0FF7A9753D}"/>
          </ac:spMkLst>
        </pc:spChg>
        <pc:spChg chg="mod">
          <ac:chgData name="美香 三木" userId="0e1e0125d0a1c367" providerId="LiveId" clId="{A5F75A57-72E0-4DB5-97A5-136CE3BC0AB1}" dt="2024-05-24T08:08:07.910" v="0"/>
          <ac:spMkLst>
            <pc:docMk/>
            <pc:sldMk cId="2905389099" sldId="260"/>
            <ac:spMk id="35" creationId="{CA32A7DE-B83F-788E-5BED-95881470C895}"/>
          </ac:spMkLst>
        </pc:spChg>
        <pc:spChg chg="mod">
          <ac:chgData name="美香 三木" userId="0e1e0125d0a1c367" providerId="LiveId" clId="{A5F75A57-72E0-4DB5-97A5-136CE3BC0AB1}" dt="2024-05-24T08:08:07.910" v="0"/>
          <ac:spMkLst>
            <pc:docMk/>
            <pc:sldMk cId="2905389099" sldId="260"/>
            <ac:spMk id="36" creationId="{B3997965-390C-48BA-F7D2-3A660ED427DF}"/>
          </ac:spMkLst>
        </pc:spChg>
        <pc:spChg chg="mod">
          <ac:chgData name="美香 三木" userId="0e1e0125d0a1c367" providerId="LiveId" clId="{A5F75A57-72E0-4DB5-97A5-136CE3BC0AB1}" dt="2024-05-24T08:08:07.910" v="0"/>
          <ac:spMkLst>
            <pc:docMk/>
            <pc:sldMk cId="2905389099" sldId="260"/>
            <ac:spMk id="38" creationId="{8DDE47F2-BC15-E4F9-AC6D-30BFB3795F84}"/>
          </ac:spMkLst>
        </pc:spChg>
        <pc:spChg chg="mod">
          <ac:chgData name="美香 三木" userId="0e1e0125d0a1c367" providerId="LiveId" clId="{A5F75A57-72E0-4DB5-97A5-136CE3BC0AB1}" dt="2024-05-24T08:08:07.910" v="0"/>
          <ac:spMkLst>
            <pc:docMk/>
            <pc:sldMk cId="2905389099" sldId="260"/>
            <ac:spMk id="40" creationId="{8B53E8FC-D365-0B32-7124-E5E0BE71C686}"/>
          </ac:spMkLst>
        </pc:spChg>
        <pc:spChg chg="mod">
          <ac:chgData name="美香 三木" userId="0e1e0125d0a1c367" providerId="LiveId" clId="{A5F75A57-72E0-4DB5-97A5-136CE3BC0AB1}" dt="2024-05-24T08:11:49.137" v="16" actId="12789"/>
          <ac:spMkLst>
            <pc:docMk/>
            <pc:sldMk cId="2905389099" sldId="260"/>
            <ac:spMk id="41" creationId="{71827D17-42BA-F41C-8854-1169C5546858}"/>
          </ac:spMkLst>
        </pc:spChg>
        <pc:spChg chg="mod">
          <ac:chgData name="美香 三木" userId="0e1e0125d0a1c367" providerId="LiveId" clId="{A5F75A57-72E0-4DB5-97A5-136CE3BC0AB1}" dt="2024-05-24T08:08:07.910" v="0"/>
          <ac:spMkLst>
            <pc:docMk/>
            <pc:sldMk cId="2905389099" sldId="260"/>
            <ac:spMk id="42" creationId="{C92D0161-E80F-6040-6D7D-356CF6400530}"/>
          </ac:spMkLst>
        </pc:spChg>
        <pc:spChg chg="mod">
          <ac:chgData name="美香 三木" userId="0e1e0125d0a1c367" providerId="LiveId" clId="{A5F75A57-72E0-4DB5-97A5-136CE3BC0AB1}" dt="2024-05-24T08:11:49.137" v="16" actId="12789"/>
          <ac:spMkLst>
            <pc:docMk/>
            <pc:sldMk cId="2905389099" sldId="260"/>
            <ac:spMk id="43" creationId="{5A5A0E2F-EAAD-78D1-4BCC-4BFDDE368A78}"/>
          </ac:spMkLst>
        </pc:spChg>
        <pc:spChg chg="mod">
          <ac:chgData name="美香 三木" userId="0e1e0125d0a1c367" providerId="LiveId" clId="{A5F75A57-72E0-4DB5-97A5-136CE3BC0AB1}" dt="2024-05-24T08:23:28.699" v="168" actId="12789"/>
          <ac:spMkLst>
            <pc:docMk/>
            <pc:sldMk cId="2905389099" sldId="260"/>
            <ac:spMk id="45" creationId="{A4E1EC35-C59E-00A5-6AC5-3D18F1DA8C93}"/>
          </ac:spMkLst>
        </pc:spChg>
        <pc:spChg chg="mod">
          <ac:chgData name="美香 三木" userId="0e1e0125d0a1c367" providerId="LiveId" clId="{A5F75A57-72E0-4DB5-97A5-136CE3BC0AB1}" dt="2024-05-24T08:23:07.916" v="165" actId="12789"/>
          <ac:spMkLst>
            <pc:docMk/>
            <pc:sldMk cId="2905389099" sldId="260"/>
            <ac:spMk id="46" creationId="{A0650309-47D8-6BE7-A83B-B007B4983A38}"/>
          </ac:spMkLst>
        </pc:spChg>
        <pc:spChg chg="mod">
          <ac:chgData name="美香 三木" userId="0e1e0125d0a1c367" providerId="LiveId" clId="{A5F75A57-72E0-4DB5-97A5-136CE3BC0AB1}" dt="2024-05-24T08:23:22.141" v="167" actId="465"/>
          <ac:spMkLst>
            <pc:docMk/>
            <pc:sldMk cId="2905389099" sldId="260"/>
            <ac:spMk id="47" creationId="{B82AB033-2103-CEC6-D43E-604C4160308B}"/>
          </ac:spMkLst>
        </pc:spChg>
        <pc:spChg chg="mod">
          <ac:chgData name="美香 三木" userId="0e1e0125d0a1c367" providerId="LiveId" clId="{A5F75A57-72E0-4DB5-97A5-136CE3BC0AB1}" dt="2024-05-24T08:22:51.548" v="163" actId="12789"/>
          <ac:spMkLst>
            <pc:docMk/>
            <pc:sldMk cId="2905389099" sldId="260"/>
            <ac:spMk id="49" creationId="{0AEF9CA2-87A0-C4A4-051B-6E85023C5868}"/>
          </ac:spMkLst>
        </pc:spChg>
        <pc:spChg chg="del">
          <ac:chgData name="美香 三木" userId="0e1e0125d0a1c367" providerId="LiveId" clId="{A5F75A57-72E0-4DB5-97A5-136CE3BC0AB1}" dt="2024-05-24T08:09:26.699" v="6" actId="478"/>
          <ac:spMkLst>
            <pc:docMk/>
            <pc:sldMk cId="2905389099" sldId="260"/>
            <ac:spMk id="51" creationId="{569D41B2-D985-B44F-F406-8C02FC46BE38}"/>
          </ac:spMkLst>
        </pc:spChg>
        <pc:spChg chg="mod">
          <ac:chgData name="美香 三木" userId="0e1e0125d0a1c367" providerId="LiveId" clId="{A5F75A57-72E0-4DB5-97A5-136CE3BC0AB1}" dt="2024-05-24T08:11:15.790" v="13" actId="1036"/>
          <ac:spMkLst>
            <pc:docMk/>
            <pc:sldMk cId="2905389099" sldId="260"/>
            <ac:spMk id="52" creationId="{5FDE8C73-5652-9E18-73C7-0BA6C452D71D}"/>
          </ac:spMkLst>
        </pc:spChg>
        <pc:spChg chg="mod">
          <ac:chgData name="美香 三木" userId="0e1e0125d0a1c367" providerId="LiveId" clId="{A5F75A57-72E0-4DB5-97A5-136CE3BC0AB1}" dt="2024-05-24T08:23:13.764" v="166" actId="12789"/>
          <ac:spMkLst>
            <pc:docMk/>
            <pc:sldMk cId="2905389099" sldId="260"/>
            <ac:spMk id="53" creationId="{E1858B8B-34E0-7FBE-133B-E3FCC9A06306}"/>
          </ac:spMkLst>
        </pc:spChg>
        <pc:spChg chg="mod">
          <ac:chgData name="美香 三木" userId="0e1e0125d0a1c367" providerId="LiveId" clId="{A5F75A57-72E0-4DB5-97A5-136CE3BC0AB1}" dt="2024-05-24T08:23:13.764" v="166" actId="12789"/>
          <ac:spMkLst>
            <pc:docMk/>
            <pc:sldMk cId="2905389099" sldId="260"/>
            <ac:spMk id="54" creationId="{BF06C7FC-2753-0053-4EC6-469B68CA343E}"/>
          </ac:spMkLst>
        </pc:spChg>
        <pc:spChg chg="mod">
          <ac:chgData name="美香 三木" userId="0e1e0125d0a1c367" providerId="LiveId" clId="{A5F75A57-72E0-4DB5-97A5-136CE3BC0AB1}" dt="2024-05-24T08:08:07.910" v="0"/>
          <ac:spMkLst>
            <pc:docMk/>
            <pc:sldMk cId="2905389099" sldId="260"/>
            <ac:spMk id="59" creationId="{FEE6AF2B-AD09-5412-D9C6-7FFE4781522B}"/>
          </ac:spMkLst>
        </pc:spChg>
        <pc:spChg chg="mod">
          <ac:chgData name="美香 三木" userId="0e1e0125d0a1c367" providerId="LiveId" clId="{A5F75A57-72E0-4DB5-97A5-136CE3BC0AB1}" dt="2024-05-24T08:08:07.910" v="0"/>
          <ac:spMkLst>
            <pc:docMk/>
            <pc:sldMk cId="2905389099" sldId="260"/>
            <ac:spMk id="60" creationId="{7A7D8B2F-74CA-DA8B-3A23-C54CA4D4315C}"/>
          </ac:spMkLst>
        </pc:spChg>
        <pc:spChg chg="mod">
          <ac:chgData name="美香 三木" userId="0e1e0125d0a1c367" providerId="LiveId" clId="{A5F75A57-72E0-4DB5-97A5-136CE3BC0AB1}" dt="2024-05-24T08:10:40.550" v="10"/>
          <ac:spMkLst>
            <pc:docMk/>
            <pc:sldMk cId="2905389099" sldId="260"/>
            <ac:spMk id="62" creationId="{0DE2DCA9-CAAB-2422-1B56-0AF57318BFFA}"/>
          </ac:spMkLst>
        </pc:spChg>
        <pc:spChg chg="mod">
          <ac:chgData name="美香 三木" userId="0e1e0125d0a1c367" providerId="LiveId" clId="{A5F75A57-72E0-4DB5-97A5-136CE3BC0AB1}" dt="2024-05-24T08:10:40.550" v="10"/>
          <ac:spMkLst>
            <pc:docMk/>
            <pc:sldMk cId="2905389099" sldId="260"/>
            <ac:spMk id="63" creationId="{A1FCC728-7CB6-2D39-904B-1EFE6C2A0269}"/>
          </ac:spMkLst>
        </pc:spChg>
        <pc:spChg chg="mod">
          <ac:chgData name="美香 三木" userId="0e1e0125d0a1c367" providerId="LiveId" clId="{A5F75A57-72E0-4DB5-97A5-136CE3BC0AB1}" dt="2024-05-24T08:16:03.312" v="28"/>
          <ac:spMkLst>
            <pc:docMk/>
            <pc:sldMk cId="2905389099" sldId="260"/>
            <ac:spMk id="65" creationId="{F95570F3-DFA4-24BE-D0F4-DCCC09F865C7}"/>
          </ac:spMkLst>
        </pc:spChg>
        <pc:spChg chg="mod">
          <ac:chgData name="美香 三木" userId="0e1e0125d0a1c367" providerId="LiveId" clId="{A5F75A57-72E0-4DB5-97A5-136CE3BC0AB1}" dt="2024-05-24T08:16:03.312" v="28"/>
          <ac:spMkLst>
            <pc:docMk/>
            <pc:sldMk cId="2905389099" sldId="260"/>
            <ac:spMk id="66" creationId="{25A33E9D-5698-0649-A064-066DB76F50B8}"/>
          </ac:spMkLst>
        </pc:spChg>
        <pc:spChg chg="add mod">
          <ac:chgData name="美香 三木" userId="0e1e0125d0a1c367" providerId="LiveId" clId="{A5F75A57-72E0-4DB5-97A5-136CE3BC0AB1}" dt="2024-05-24T08:21:37.486" v="153" actId="1076"/>
          <ac:spMkLst>
            <pc:docMk/>
            <pc:sldMk cId="2905389099" sldId="260"/>
            <ac:spMk id="67" creationId="{F63172CC-3A7A-AC85-1EE5-0ADDFE27CEAC}"/>
          </ac:spMkLst>
        </pc:spChg>
        <pc:grpChg chg="add mod">
          <ac:chgData name="美香 三木" userId="0e1e0125d0a1c367" providerId="LiveId" clId="{A5F75A57-72E0-4DB5-97A5-136CE3BC0AB1}" dt="2024-05-24T08:18:11.997" v="36" actId="1076"/>
          <ac:grpSpMkLst>
            <pc:docMk/>
            <pc:sldMk cId="2905389099" sldId="260"/>
            <ac:grpSpMk id="12" creationId="{BE2F3987-A2E2-932A-1215-B0380F697437}"/>
          </ac:grpSpMkLst>
        </pc:grpChg>
        <pc:grpChg chg="mod">
          <ac:chgData name="美香 三木" userId="0e1e0125d0a1c367" providerId="LiveId" clId="{A5F75A57-72E0-4DB5-97A5-136CE3BC0AB1}" dt="2024-05-24T08:08:07.910" v="0"/>
          <ac:grpSpMkLst>
            <pc:docMk/>
            <pc:sldMk cId="2905389099" sldId="260"/>
            <ac:grpSpMk id="39" creationId="{A3014382-C272-25E2-5521-CC86833BB561}"/>
          </ac:grpSpMkLst>
        </pc:grpChg>
        <pc:grpChg chg="add mod">
          <ac:chgData name="美香 三木" userId="0e1e0125d0a1c367" providerId="LiveId" clId="{A5F75A57-72E0-4DB5-97A5-136CE3BC0AB1}" dt="2024-05-24T08:23:28.699" v="168" actId="12789"/>
          <ac:grpSpMkLst>
            <pc:docMk/>
            <pc:sldMk cId="2905389099" sldId="260"/>
            <ac:grpSpMk id="61" creationId="{A7340FFC-9191-AE43-D1FA-91B2FB4BCD70}"/>
          </ac:grpSpMkLst>
        </pc:grpChg>
        <pc:grpChg chg="add del mod">
          <ac:chgData name="美香 三木" userId="0e1e0125d0a1c367" providerId="LiveId" clId="{A5F75A57-72E0-4DB5-97A5-136CE3BC0AB1}" dt="2024-05-24T08:21:40.262" v="154" actId="478"/>
          <ac:grpSpMkLst>
            <pc:docMk/>
            <pc:sldMk cId="2905389099" sldId="260"/>
            <ac:grpSpMk id="64" creationId="{845D52E0-E8E4-326F-F2ED-9548EF0F352B}"/>
          </ac:grpSpMkLst>
        </pc:grpChg>
        <pc:picChg chg="del">
          <ac:chgData name="美香 三木" userId="0e1e0125d0a1c367" providerId="LiveId" clId="{A5F75A57-72E0-4DB5-97A5-136CE3BC0AB1}" dt="2024-05-24T08:09:26.699" v="6" actId="478"/>
          <ac:picMkLst>
            <pc:docMk/>
            <pc:sldMk cId="2905389099" sldId="260"/>
            <ac:picMk id="4" creationId="{AC9FF24C-B9B5-C1D3-491C-CF40FF932651}"/>
          </ac:picMkLst>
        </pc:picChg>
        <pc:picChg chg="del">
          <ac:chgData name="美香 三木" userId="0e1e0125d0a1c367" providerId="LiveId" clId="{A5F75A57-72E0-4DB5-97A5-136CE3BC0AB1}" dt="2024-05-24T08:09:26.699" v="6" actId="478"/>
          <ac:picMkLst>
            <pc:docMk/>
            <pc:sldMk cId="2905389099" sldId="260"/>
            <ac:picMk id="5" creationId="{CD5BC4AE-DE1D-897F-AC10-EE65C4D63A6F}"/>
          </ac:picMkLst>
        </pc:picChg>
        <pc:picChg chg="del">
          <ac:chgData name="美香 三木" userId="0e1e0125d0a1c367" providerId="LiveId" clId="{A5F75A57-72E0-4DB5-97A5-136CE3BC0AB1}" dt="2024-05-24T08:09:26.699" v="6" actId="478"/>
          <ac:picMkLst>
            <pc:docMk/>
            <pc:sldMk cId="2905389099" sldId="260"/>
            <ac:picMk id="6" creationId="{A5D5F3D7-2A45-87AF-B0AE-A233DD697169}"/>
          </ac:picMkLst>
        </pc:picChg>
        <pc:picChg chg="del">
          <ac:chgData name="美香 三木" userId="0e1e0125d0a1c367" providerId="LiveId" clId="{A5F75A57-72E0-4DB5-97A5-136CE3BC0AB1}" dt="2024-05-24T08:09:26.699" v="6" actId="478"/>
          <ac:picMkLst>
            <pc:docMk/>
            <pc:sldMk cId="2905389099" sldId="260"/>
            <ac:picMk id="8" creationId="{2AB11CA7-B56F-2FF0-EA03-19FD06828E7D}"/>
          </ac:picMkLst>
        </pc:picChg>
        <pc:picChg chg="mod">
          <ac:chgData name="美香 三木" userId="0e1e0125d0a1c367" providerId="LiveId" clId="{A5F75A57-72E0-4DB5-97A5-136CE3BC0AB1}" dt="2024-05-24T08:17:38.569" v="34" actId="554"/>
          <ac:picMkLst>
            <pc:docMk/>
            <pc:sldMk cId="2905389099" sldId="260"/>
            <ac:picMk id="9" creationId="{D1089652-F2CD-B549-FEB9-27B05F860E5B}"/>
          </ac:picMkLst>
        </pc:picChg>
        <pc:cxnChg chg="mod">
          <ac:chgData name="美香 三木" userId="0e1e0125d0a1c367" providerId="LiveId" clId="{A5F75A57-72E0-4DB5-97A5-136CE3BC0AB1}" dt="2024-05-24T08:08:07.910" v="0"/>
          <ac:cxnSpMkLst>
            <pc:docMk/>
            <pc:sldMk cId="2905389099" sldId="260"/>
            <ac:cxnSpMk id="13" creationId="{5CD483E4-D512-D781-3265-318C1C405351}"/>
          </ac:cxnSpMkLst>
        </pc:cxnChg>
        <pc:cxnChg chg="del">
          <ac:chgData name="美香 三木" userId="0e1e0125d0a1c367" providerId="LiveId" clId="{A5F75A57-72E0-4DB5-97A5-136CE3BC0AB1}" dt="2024-05-24T08:08:18.771" v="2" actId="478"/>
          <ac:cxnSpMkLst>
            <pc:docMk/>
            <pc:sldMk cId="2905389099" sldId="260"/>
            <ac:cxnSpMk id="27" creationId="{B77024C0-B75F-CBCF-FEFA-1B8150C351C7}"/>
          </ac:cxnSpMkLst>
        </pc:cxnChg>
        <pc:cxnChg chg="del">
          <ac:chgData name="美香 三木" userId="0e1e0125d0a1c367" providerId="LiveId" clId="{A5F75A57-72E0-4DB5-97A5-136CE3BC0AB1}" dt="2024-05-24T08:08:18.771" v="2" actId="478"/>
          <ac:cxnSpMkLst>
            <pc:docMk/>
            <pc:sldMk cId="2905389099" sldId="260"/>
            <ac:cxnSpMk id="28" creationId="{B0D7D441-A9BB-AFB1-A19A-3968EC6DAFB3}"/>
          </ac:cxnSpMkLst>
        </pc:cxnChg>
        <pc:cxnChg chg="del">
          <ac:chgData name="美香 三木" userId="0e1e0125d0a1c367" providerId="LiveId" clId="{A5F75A57-72E0-4DB5-97A5-136CE3BC0AB1}" dt="2024-05-24T08:08:18.771" v="2" actId="478"/>
          <ac:cxnSpMkLst>
            <pc:docMk/>
            <pc:sldMk cId="2905389099" sldId="260"/>
            <ac:cxnSpMk id="30" creationId="{3C8BBC5B-1901-82B0-F64E-2EBEBEC72471}"/>
          </ac:cxnSpMkLst>
        </pc:cxnChg>
        <pc:cxnChg chg="del">
          <ac:chgData name="美香 三木" userId="0e1e0125d0a1c367" providerId="LiveId" clId="{A5F75A57-72E0-4DB5-97A5-136CE3BC0AB1}" dt="2024-05-24T08:08:18.771" v="2" actId="478"/>
          <ac:cxnSpMkLst>
            <pc:docMk/>
            <pc:sldMk cId="2905389099" sldId="260"/>
            <ac:cxnSpMk id="31" creationId="{5218F9A1-7DF7-94E1-4914-D8EFBEF1F001}"/>
          </ac:cxnSpMkLst>
        </pc:cxnChg>
        <pc:cxnChg chg="del">
          <ac:chgData name="美香 三木" userId="0e1e0125d0a1c367" providerId="LiveId" clId="{A5F75A57-72E0-4DB5-97A5-136CE3BC0AB1}" dt="2024-05-24T08:08:21.734" v="3" actId="478"/>
          <ac:cxnSpMkLst>
            <pc:docMk/>
            <pc:sldMk cId="2905389099" sldId="260"/>
            <ac:cxnSpMk id="37" creationId="{E8457B05-9907-05B7-EC93-1E984CF24FFA}"/>
          </ac:cxnSpMkLst>
        </pc:cxnChg>
        <pc:cxnChg chg="del">
          <ac:chgData name="美香 三木" userId="0e1e0125d0a1c367" providerId="LiveId" clId="{A5F75A57-72E0-4DB5-97A5-136CE3BC0AB1}" dt="2024-05-24T08:09:30.498" v="7" actId="478"/>
          <ac:cxnSpMkLst>
            <pc:docMk/>
            <pc:sldMk cId="2905389099" sldId="260"/>
            <ac:cxnSpMk id="44" creationId="{B32939E7-E823-AD24-054D-FD00F631B343}"/>
          </ac:cxnSpMkLst>
        </pc:cxnChg>
        <pc:cxnChg chg="mod">
          <ac:chgData name="美香 三木" userId="0e1e0125d0a1c367" providerId="LiveId" clId="{A5F75A57-72E0-4DB5-97A5-136CE3BC0AB1}" dt="2024-05-24T08:22:51.548" v="163" actId="12789"/>
          <ac:cxnSpMkLst>
            <pc:docMk/>
            <pc:sldMk cId="2905389099" sldId="260"/>
            <ac:cxnSpMk id="48" creationId="{2E0A115A-6D5D-F07C-60DF-E14BC0CA39AF}"/>
          </ac:cxnSpMkLst>
        </pc:cxnChg>
        <pc:cxnChg chg="del">
          <ac:chgData name="美香 三木" userId="0e1e0125d0a1c367" providerId="LiveId" clId="{A5F75A57-72E0-4DB5-97A5-136CE3BC0AB1}" dt="2024-05-24T08:09:26.699" v="6" actId="478"/>
          <ac:cxnSpMkLst>
            <pc:docMk/>
            <pc:sldMk cId="2905389099" sldId="260"/>
            <ac:cxnSpMk id="50" creationId="{679CDCAD-22AC-ABA5-E315-D6E34A06D6ED}"/>
          </ac:cxnSpMkLst>
        </pc:cxnChg>
      </pc:sldChg>
    </pc:docChg>
  </pc:docChgLst>
</pc:chgInfo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>
            <a:extLst>
              <a:ext uri="{FF2B5EF4-FFF2-40B4-BE49-F238E27FC236}">
                <a16:creationId xmlns:a16="http://schemas.microsoft.com/office/drawing/2014/main" id="{04625B53-AE11-5122-EFE6-75EC7D54C3FA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2EC39038-AF43-0B83-E826-ACA9732A51C7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856038" y="0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93F8D0E-0CC4-4AAF-AE7E-64C0EC0BF644}" type="datetimeFigureOut">
              <a:rPr kumimoji="1" lang="ja-JP" altLang="en-US" smtClean="0"/>
              <a:t>2024/8/13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FAA02014-EB19-B0B2-D018-E20382624733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9440863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FFEC58D6-529D-0119-F062-86AA9B96EC6F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856038" y="9440863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2ED1BF8-5685-48A9-B649-F4FEB36459F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5216872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787" cy="49869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5838" y="0"/>
            <a:ext cx="2949787" cy="49869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695236E-E920-4B6E-B3E2-9E4C923C2F1B}" type="datetimeFigureOut">
              <a:rPr kumimoji="1" lang="ja-JP" altLang="en-US" smtClean="0"/>
              <a:t>2024/8/1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422275" y="1243013"/>
            <a:ext cx="5962650" cy="33543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0720" y="4783307"/>
            <a:ext cx="5445760" cy="3913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40647"/>
            <a:ext cx="2949787" cy="49869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5838" y="9440647"/>
            <a:ext cx="2949787" cy="49869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13EF7BD-8E6B-4D97-A14E-ACC8A82F887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476614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13EF7BD-8E6B-4D97-A14E-ACC8A82F887F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4519572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566056D-9C2E-796D-10A1-03D3D39C779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BD70929E-E5C6-00EE-B86F-99AC71A9054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D8895EE-4382-AC30-96E4-8C536CC74A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8901F3-94A8-F446-956B-4DE4376818BD}" type="datetimeFigureOut">
              <a:rPr kumimoji="1" lang="ja-JP" altLang="en-US" smtClean="0"/>
              <a:t>2024/8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8C9FB59-A507-123D-EDCD-AAAA158A4E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FB1C774-4F23-6B4A-9966-4A85DE7257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72D20C-42D6-2F4C-BAD8-ABD50E71E1B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346351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F5E8CF7-2EF5-3C30-36EF-D5F4E9FE3E2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B1C7FE2E-2F29-3E84-302D-6795C538C43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6ED1A8D-9DEC-BFC1-3CA1-6B27875E17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8901F3-94A8-F446-956B-4DE4376818BD}" type="datetimeFigureOut">
              <a:rPr kumimoji="1" lang="ja-JP" altLang="en-US" smtClean="0"/>
              <a:t>2024/8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0B46B13-5BA4-017E-5A57-9BE895FFBD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EADC82D-0141-460C-0647-CF4176AA7B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72D20C-42D6-2F4C-BAD8-ABD50E71E1B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175104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664A95E9-5D25-2FF7-F98E-A3A8E28A849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3BA13AC5-0A34-A6E7-326B-86347066DBB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151D9E7-D81B-E6A9-03CA-26F270799E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8901F3-94A8-F446-956B-4DE4376818BD}" type="datetimeFigureOut">
              <a:rPr kumimoji="1" lang="ja-JP" altLang="en-US" smtClean="0"/>
              <a:t>2024/8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59CE5A4-1297-0DF6-43AC-1F78487266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AD5FF5B-A26C-6791-418A-0FA7A27339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72D20C-42D6-2F4C-BAD8-ABD50E71E1B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641328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01B951B-14F3-3784-FCC1-EBEBD4156F8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7EAA5169-662D-9B78-7350-95C318B8F07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015DE6A-AB4E-19C2-3B77-2CAFD42CDC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8901F3-94A8-F446-956B-4DE4376818BD}" type="datetimeFigureOut">
              <a:rPr kumimoji="1" lang="ja-JP" altLang="en-US" smtClean="0"/>
              <a:t>2024/8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E3B639A-34C5-CF0E-CDDC-6CD1094952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2810592-072E-ADFB-67BB-70259C2FC4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72D20C-42D6-2F4C-BAD8-ABD50E71E1B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049790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65650F2-0E3C-53E8-E16E-06664A61D0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C523F15-2768-C4E6-3876-D64EC5C9F04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32E070E-D048-4A7F-DC89-3FAE17E950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8901F3-94A8-F446-956B-4DE4376818BD}" type="datetimeFigureOut">
              <a:rPr kumimoji="1" lang="ja-JP" altLang="en-US" smtClean="0"/>
              <a:t>2024/8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7BF18AE-F75C-8DFC-9F73-4B59E43D85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4327951-3DD7-11FB-6648-37EB4F156B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72D20C-42D6-2F4C-BAD8-ABD50E71E1B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263620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B8C9D9A-8BB6-5DA5-E431-FF9A0D73FC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A0B377F-9422-D6D4-BC32-14B0AFE13BC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87A94A2F-050D-6565-151B-B69542EA617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5899F12D-4B5F-B360-FDBC-464D36D599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8901F3-94A8-F446-956B-4DE4376818BD}" type="datetimeFigureOut">
              <a:rPr kumimoji="1" lang="ja-JP" altLang="en-US" smtClean="0"/>
              <a:t>2024/8/1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7234059A-52ED-20A8-AA6A-75F7818840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48089B0B-23BC-D261-A496-70D031BF19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72D20C-42D6-2F4C-BAD8-ABD50E71E1B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42286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5B1AC73-A89C-90FB-FC7A-EEE5962059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6E50A3D0-B24F-C621-0E42-46E4CD33FD5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5F35841D-A79C-8AE5-0A92-7E446C745F7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E75044D0-3687-A79D-90EB-2A3C029D749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AB516F91-98A0-9ECC-076E-D49144159E1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E3412C04-4B9B-8E11-AADB-29705A784C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8901F3-94A8-F446-956B-4DE4376818BD}" type="datetimeFigureOut">
              <a:rPr kumimoji="1" lang="ja-JP" altLang="en-US" smtClean="0"/>
              <a:t>2024/8/13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3A818E15-1A17-4092-1531-CBAD9CF076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6E7B9983-BEC4-8280-E0D7-68617B526D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72D20C-42D6-2F4C-BAD8-ABD50E71E1B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855816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7D20919-CE36-F836-F3A7-B810ACD831E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CE47ECD0-6C75-545E-3ADD-307915DF60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8901F3-94A8-F446-956B-4DE4376818BD}" type="datetimeFigureOut">
              <a:rPr kumimoji="1" lang="ja-JP" altLang="en-US" smtClean="0"/>
              <a:t>2024/8/13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FAFF9025-59D5-C938-6E2A-8F73947EC6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7E73DD91-DE3C-9BF5-E5A9-50BA65542B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72D20C-42D6-2F4C-BAD8-ABD50E71E1B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428676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29FFA73B-46E4-578A-CB4B-F93EA65D07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8901F3-94A8-F446-956B-4DE4376818BD}" type="datetimeFigureOut">
              <a:rPr kumimoji="1" lang="ja-JP" altLang="en-US" smtClean="0"/>
              <a:t>2024/8/13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F91AFA1E-C738-5555-216B-15EE8A5827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214B8D96-9A64-6807-2439-E41E2672AA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72D20C-42D6-2F4C-BAD8-ABD50E71E1B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457679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F853326-9289-39FF-643A-9B9FB6E0AE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6056E42-92A4-F1DD-39FE-667AE3DD133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EB20BC6D-7F78-B1F1-EECF-24A99AC1F37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8EB90C2A-A081-B0C0-B72D-98D31FC122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8901F3-94A8-F446-956B-4DE4376818BD}" type="datetimeFigureOut">
              <a:rPr kumimoji="1" lang="ja-JP" altLang="en-US" smtClean="0"/>
              <a:t>2024/8/1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660A60F-D541-05D6-175E-64D1A9C2B9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5369A0A4-9012-8B47-35B6-2428C143D6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72D20C-42D6-2F4C-BAD8-ABD50E71E1B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969604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269B34C-AAF6-0CED-553D-5C481AB22B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D837CA37-F938-B68C-0AE6-A48F7713940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B9C8FF75-FBC9-C257-5897-06620009B21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BC4344FF-6A3D-4C8A-4A7D-3A371424BA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8901F3-94A8-F446-956B-4DE4376818BD}" type="datetimeFigureOut">
              <a:rPr kumimoji="1" lang="ja-JP" altLang="en-US" smtClean="0"/>
              <a:t>2024/8/1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71F3316-BEE9-9CB2-042D-A01B70AB0B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439FBC11-0170-CF93-7077-904A4C72E3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72D20C-42D6-2F4C-BAD8-ABD50E71E1B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790063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F97A0BC7-6EB2-6AC8-3913-55A10C5EAC4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2AEA2FE9-CB59-819A-825A-B1523F6971A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CD2F50D-3F23-882D-D7A2-0517C6DDED6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8901F3-94A8-F446-956B-4DE4376818BD}" type="datetimeFigureOut">
              <a:rPr kumimoji="1" lang="ja-JP" altLang="en-US" smtClean="0"/>
              <a:t>2024/8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3B270DB-5B36-711B-4816-73B964F6F37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6E97783-8AE6-F271-520D-0D3BB9D093B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72D20C-42D6-2F4C-BAD8-ABD50E71E1B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744939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emf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0D32CA26-8924-CEA5-F45E-B4AB2D121836}"/>
              </a:ext>
            </a:extLst>
          </p:cNvPr>
          <p:cNvSpPr txBox="1"/>
          <p:nvPr/>
        </p:nvSpPr>
        <p:spPr>
          <a:xfrm>
            <a:off x="147660" y="44777"/>
            <a:ext cx="370244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kumimoji="1" lang="en-US" altLang="ja-JP" sz="2400" b="1">
                <a:latin typeface="Arial" panose="020B0604020202020204" pitchFamily="34" charset="0"/>
                <a:cs typeface="Arial" panose="020B0604020202020204" pitchFamily="34" charset="0"/>
              </a:rPr>
              <a:t>Figure 2</a:t>
            </a:r>
            <a:endParaRPr kumimoji="1" lang="ja-JP" altLang="en-US" sz="2400" dirty="0"/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DF2A746E-A7DC-5B3A-A8FD-95E8C04AFAA3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1769" r="2722" b="2962"/>
          <a:stretch/>
        </p:blipFill>
        <p:spPr>
          <a:xfrm>
            <a:off x="1179846" y="537101"/>
            <a:ext cx="2785766" cy="2038893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4F3B4011-9DC7-C801-4171-92AE34569525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2283" t="6022" r="1713" b="28941"/>
          <a:stretch/>
        </p:blipFill>
        <p:spPr>
          <a:xfrm>
            <a:off x="4639379" y="535072"/>
            <a:ext cx="6443231" cy="3026234"/>
          </a:xfrm>
          <a:prstGeom prst="rect">
            <a:avLst/>
          </a:prstGeom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D1089652-F2CD-B549-FEB9-27B05F860E5B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8536" t="4892" r="1655" b="6768"/>
          <a:stretch/>
        </p:blipFill>
        <p:spPr>
          <a:xfrm>
            <a:off x="1179847" y="2622619"/>
            <a:ext cx="2785766" cy="2132929"/>
          </a:xfrm>
          <a:prstGeom prst="rect">
            <a:avLst/>
          </a:prstGeom>
        </p:spPr>
      </p:pic>
      <p:pic>
        <p:nvPicPr>
          <p:cNvPr id="10" name="図 9">
            <a:extLst>
              <a:ext uri="{FF2B5EF4-FFF2-40B4-BE49-F238E27FC236}">
                <a16:creationId xmlns:a16="http://schemas.microsoft.com/office/drawing/2014/main" id="{D258F875-3CE7-7467-9F7D-34AA07F33364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6710" t="10209" r="4817" b="4956"/>
          <a:stretch/>
        </p:blipFill>
        <p:spPr>
          <a:xfrm>
            <a:off x="1189470" y="4809812"/>
            <a:ext cx="2785705" cy="1992530"/>
          </a:xfrm>
          <a:prstGeom prst="rect">
            <a:avLst/>
          </a:prstGeom>
        </p:spPr>
      </p:pic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C5A33759-A388-936E-A0FC-3CC62702ADA3}"/>
              </a:ext>
            </a:extLst>
          </p:cNvPr>
          <p:cNvSpPr txBox="1"/>
          <p:nvPr/>
        </p:nvSpPr>
        <p:spPr>
          <a:xfrm>
            <a:off x="1179845" y="535071"/>
            <a:ext cx="2118399" cy="3077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ja-JP" sz="1400" b="1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Three years ago: FPPA</a:t>
            </a:r>
            <a:endParaRPr lang="ja-JP" altLang="en-US" sz="1400" b="1" dirty="0"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17D87040-F06C-D514-75A2-ABB995564BD4}"/>
              </a:ext>
            </a:extLst>
          </p:cNvPr>
          <p:cNvSpPr txBox="1"/>
          <p:nvPr/>
        </p:nvSpPr>
        <p:spPr>
          <a:xfrm>
            <a:off x="4639378" y="516919"/>
            <a:ext cx="2021304" cy="33855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ja-JP" sz="1600" b="1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At diagnosis: UPA</a:t>
            </a:r>
            <a:endParaRPr lang="ja-JP" altLang="en-US" sz="1600" b="1" dirty="0"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00993567-9894-B5E6-ECDE-193A28F51F3C}"/>
              </a:ext>
            </a:extLst>
          </p:cNvPr>
          <p:cNvSpPr txBox="1"/>
          <p:nvPr/>
        </p:nvSpPr>
        <p:spPr>
          <a:xfrm>
            <a:off x="1147796" y="2622619"/>
            <a:ext cx="2071135" cy="3077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ja-JP" sz="1400" b="1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Two years ago: FPPA</a:t>
            </a:r>
            <a:endParaRPr lang="ja-JP" altLang="en-US" sz="1400" b="1" dirty="0"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D0E8260C-DF3A-F700-E0C0-875D64F726E2}"/>
              </a:ext>
            </a:extLst>
          </p:cNvPr>
          <p:cNvSpPr txBox="1"/>
          <p:nvPr/>
        </p:nvSpPr>
        <p:spPr>
          <a:xfrm>
            <a:off x="1179845" y="4807782"/>
            <a:ext cx="2516257" cy="3077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ja-JP" sz="1400" b="1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One year ago: FPPA</a:t>
            </a:r>
            <a:r>
              <a:rPr lang="ja-JP" altLang="en-US" sz="14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→</a:t>
            </a:r>
            <a:r>
              <a:rPr lang="en-US" altLang="ja-JP" sz="1400" b="1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UPA</a:t>
            </a:r>
            <a:endParaRPr lang="ja-JP" altLang="en-US" sz="1400" b="1" dirty="0"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7" name="三角形 16">
            <a:extLst>
              <a:ext uri="{FF2B5EF4-FFF2-40B4-BE49-F238E27FC236}">
                <a16:creationId xmlns:a16="http://schemas.microsoft.com/office/drawing/2014/main" id="{F2ECC99F-3AEC-3B30-907B-E43126B3FB24}"/>
              </a:ext>
            </a:extLst>
          </p:cNvPr>
          <p:cNvSpPr/>
          <p:nvPr/>
        </p:nvSpPr>
        <p:spPr>
          <a:xfrm rot="12407103">
            <a:off x="2567623" y="1055640"/>
            <a:ext cx="221381" cy="226231"/>
          </a:xfrm>
          <a:prstGeom prst="triangle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9" name="三角形 18">
            <a:extLst>
              <a:ext uri="{FF2B5EF4-FFF2-40B4-BE49-F238E27FC236}">
                <a16:creationId xmlns:a16="http://schemas.microsoft.com/office/drawing/2014/main" id="{8A9F5527-A521-B66B-1E53-7F899C37A8E7}"/>
              </a:ext>
            </a:extLst>
          </p:cNvPr>
          <p:cNvSpPr/>
          <p:nvPr/>
        </p:nvSpPr>
        <p:spPr>
          <a:xfrm rot="12407103">
            <a:off x="2738702" y="3235806"/>
            <a:ext cx="221381" cy="226231"/>
          </a:xfrm>
          <a:prstGeom prst="triangle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0" name="三角形 19">
            <a:extLst>
              <a:ext uri="{FF2B5EF4-FFF2-40B4-BE49-F238E27FC236}">
                <a16:creationId xmlns:a16="http://schemas.microsoft.com/office/drawing/2014/main" id="{9E2FD586-9615-5F9B-1BFC-B6530B2ED246}"/>
              </a:ext>
            </a:extLst>
          </p:cNvPr>
          <p:cNvSpPr/>
          <p:nvPr/>
        </p:nvSpPr>
        <p:spPr>
          <a:xfrm rot="12407103">
            <a:off x="2477215" y="5380638"/>
            <a:ext cx="221381" cy="226231"/>
          </a:xfrm>
          <a:prstGeom prst="triangle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1" name="三角形 20">
            <a:extLst>
              <a:ext uri="{FF2B5EF4-FFF2-40B4-BE49-F238E27FC236}">
                <a16:creationId xmlns:a16="http://schemas.microsoft.com/office/drawing/2014/main" id="{4FBFC8FA-D278-60BB-82D7-ED569FA53B44}"/>
              </a:ext>
            </a:extLst>
          </p:cNvPr>
          <p:cNvSpPr/>
          <p:nvPr/>
        </p:nvSpPr>
        <p:spPr>
          <a:xfrm rot="12407103">
            <a:off x="7900402" y="2011792"/>
            <a:ext cx="221381" cy="226231"/>
          </a:xfrm>
          <a:prstGeom prst="triangle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2" name="三角形 21">
            <a:extLst>
              <a:ext uri="{FF2B5EF4-FFF2-40B4-BE49-F238E27FC236}">
                <a16:creationId xmlns:a16="http://schemas.microsoft.com/office/drawing/2014/main" id="{C6655B11-8F07-2E5E-BE7B-948EED436E9F}"/>
              </a:ext>
            </a:extLst>
          </p:cNvPr>
          <p:cNvSpPr/>
          <p:nvPr/>
        </p:nvSpPr>
        <p:spPr>
          <a:xfrm rot="12407103">
            <a:off x="8313396" y="2319014"/>
            <a:ext cx="174157" cy="178186"/>
          </a:xfrm>
          <a:prstGeom prst="triangl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3" name="三角形 22">
            <a:extLst>
              <a:ext uri="{FF2B5EF4-FFF2-40B4-BE49-F238E27FC236}">
                <a16:creationId xmlns:a16="http://schemas.microsoft.com/office/drawing/2014/main" id="{2196848B-6916-719B-9DB1-2CD28A5D771A}"/>
              </a:ext>
            </a:extLst>
          </p:cNvPr>
          <p:cNvSpPr/>
          <p:nvPr/>
        </p:nvSpPr>
        <p:spPr>
          <a:xfrm rot="12407103">
            <a:off x="8725679" y="2471414"/>
            <a:ext cx="174157" cy="178186"/>
          </a:xfrm>
          <a:prstGeom prst="triangl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4" name="三角形 23">
            <a:extLst>
              <a:ext uri="{FF2B5EF4-FFF2-40B4-BE49-F238E27FC236}">
                <a16:creationId xmlns:a16="http://schemas.microsoft.com/office/drawing/2014/main" id="{16E878F4-52F7-AE0D-3E47-D9F9C528618E}"/>
              </a:ext>
            </a:extLst>
          </p:cNvPr>
          <p:cNvSpPr/>
          <p:nvPr/>
        </p:nvSpPr>
        <p:spPr>
          <a:xfrm rot="12407103">
            <a:off x="9139565" y="2509915"/>
            <a:ext cx="174157" cy="178186"/>
          </a:xfrm>
          <a:prstGeom prst="triangl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5" name="三角形 24">
            <a:extLst>
              <a:ext uri="{FF2B5EF4-FFF2-40B4-BE49-F238E27FC236}">
                <a16:creationId xmlns:a16="http://schemas.microsoft.com/office/drawing/2014/main" id="{8688E608-3C6A-7CDB-85E3-0823B738A008}"/>
              </a:ext>
            </a:extLst>
          </p:cNvPr>
          <p:cNvSpPr/>
          <p:nvPr/>
        </p:nvSpPr>
        <p:spPr>
          <a:xfrm rot="12407103">
            <a:off x="9457199" y="2740922"/>
            <a:ext cx="174157" cy="178186"/>
          </a:xfrm>
          <a:prstGeom prst="triangl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6" name="三角形 25">
            <a:extLst>
              <a:ext uri="{FF2B5EF4-FFF2-40B4-BE49-F238E27FC236}">
                <a16:creationId xmlns:a16="http://schemas.microsoft.com/office/drawing/2014/main" id="{B7CEA693-DCB8-D4D5-CA8C-92882E4A5F0F}"/>
              </a:ext>
            </a:extLst>
          </p:cNvPr>
          <p:cNvSpPr/>
          <p:nvPr/>
        </p:nvSpPr>
        <p:spPr>
          <a:xfrm rot="12407103">
            <a:off x="9871085" y="2923802"/>
            <a:ext cx="174157" cy="178186"/>
          </a:xfrm>
          <a:prstGeom prst="triangl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A4E1EC35-C59E-00A5-6AC5-3D18F1DA8C93}"/>
              </a:ext>
            </a:extLst>
          </p:cNvPr>
          <p:cNvSpPr txBox="1"/>
          <p:nvPr/>
        </p:nvSpPr>
        <p:spPr>
          <a:xfrm>
            <a:off x="7823410" y="5424318"/>
            <a:ext cx="162440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MPD stenosis</a:t>
            </a:r>
            <a:endParaRPr kumimoji="1" lang="ja-JP" altLang="en-US" sz="1600" dirty="0"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46" name="正方形/長方形 45">
            <a:extLst>
              <a:ext uri="{FF2B5EF4-FFF2-40B4-BE49-F238E27FC236}">
                <a16:creationId xmlns:a16="http://schemas.microsoft.com/office/drawing/2014/main" id="{A0650309-47D8-6BE7-A83B-B007B4983A38}"/>
              </a:ext>
            </a:extLst>
          </p:cNvPr>
          <p:cNvSpPr/>
          <p:nvPr/>
        </p:nvSpPr>
        <p:spPr>
          <a:xfrm>
            <a:off x="6767992" y="5906773"/>
            <a:ext cx="806823" cy="127304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B82AB033-2103-CEC6-D43E-604C4160308B}"/>
              </a:ext>
            </a:extLst>
          </p:cNvPr>
          <p:cNvSpPr txBox="1"/>
          <p:nvPr/>
        </p:nvSpPr>
        <p:spPr>
          <a:xfrm>
            <a:off x="7823410" y="5801148"/>
            <a:ext cx="38609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Intraductal </a:t>
            </a:r>
            <a:r>
              <a:rPr lang="en-US" altLang="ja-JP" sz="1600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exten</a:t>
            </a:r>
            <a:r>
              <a:rPr kumimoji="1" lang="en-US" altLang="ja-JP" sz="1600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sion of cancer</a:t>
            </a:r>
            <a:endParaRPr kumimoji="1" lang="ja-JP" altLang="en-US" sz="1600" dirty="0"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cxnSp>
        <p:nvCxnSpPr>
          <p:cNvPr id="48" name="直線矢印コネクタ 47">
            <a:extLst>
              <a:ext uri="{FF2B5EF4-FFF2-40B4-BE49-F238E27FC236}">
                <a16:creationId xmlns:a16="http://schemas.microsoft.com/office/drawing/2014/main" id="{2E0A115A-6D5D-F07C-60DF-E14BC0CA39AF}"/>
              </a:ext>
            </a:extLst>
          </p:cNvPr>
          <p:cNvCxnSpPr>
            <a:cxnSpLocks/>
          </p:cNvCxnSpPr>
          <p:nvPr/>
        </p:nvCxnSpPr>
        <p:spPr>
          <a:xfrm>
            <a:off x="6751855" y="5216765"/>
            <a:ext cx="839096" cy="0"/>
          </a:xfrm>
          <a:prstGeom prst="straightConnector1">
            <a:avLst/>
          </a:prstGeom>
          <a:ln w="57150">
            <a:solidFill>
              <a:schemeClr val="accent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0AEF9CA2-87A0-C4A4-051B-6E85023C5868}"/>
              </a:ext>
            </a:extLst>
          </p:cNvPr>
          <p:cNvSpPr txBox="1"/>
          <p:nvPr/>
        </p:nvSpPr>
        <p:spPr>
          <a:xfrm>
            <a:off x="7823410" y="5047488"/>
            <a:ext cx="413046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Histopathological</a:t>
            </a:r>
            <a:r>
              <a:rPr lang="ja-JP" altLang="en-US" sz="1600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 </a:t>
            </a:r>
            <a:r>
              <a:rPr lang="en-US" altLang="ja-JP" sz="1600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pancreatic</a:t>
            </a:r>
            <a:r>
              <a:rPr lang="ja-JP" altLang="en-US" sz="1600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 </a:t>
            </a:r>
            <a:r>
              <a:rPr lang="en-US" altLang="ja-JP" sz="1600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atrophy</a:t>
            </a:r>
            <a:endParaRPr kumimoji="1" lang="ja-JP" altLang="en-US" sz="1600" dirty="0"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53" name="正方形/長方形 52">
            <a:extLst>
              <a:ext uri="{FF2B5EF4-FFF2-40B4-BE49-F238E27FC236}">
                <a16:creationId xmlns:a16="http://schemas.microsoft.com/office/drawing/2014/main" id="{E1858B8B-34E0-7FBE-133B-E3FCC9A06306}"/>
              </a:ext>
            </a:extLst>
          </p:cNvPr>
          <p:cNvSpPr/>
          <p:nvPr/>
        </p:nvSpPr>
        <p:spPr>
          <a:xfrm>
            <a:off x="6767992" y="6283603"/>
            <a:ext cx="806823" cy="127304"/>
          </a:xfrm>
          <a:prstGeom prst="rect">
            <a:avLst/>
          </a:prstGeom>
          <a:solidFill>
            <a:srgbClr val="C88E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BF06C7FC-2753-0053-4EC6-469B68CA343E}"/>
              </a:ext>
            </a:extLst>
          </p:cNvPr>
          <p:cNvSpPr txBox="1"/>
          <p:nvPr/>
        </p:nvSpPr>
        <p:spPr>
          <a:xfrm>
            <a:off x="7823410" y="6177978"/>
            <a:ext cx="38609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Microin</a:t>
            </a:r>
            <a:r>
              <a:rPr kumimoji="1" lang="en-US" altLang="ja-JP" sz="1600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vasive cancer</a:t>
            </a:r>
            <a:endParaRPr kumimoji="1" lang="ja-JP" altLang="en-US" sz="1600" dirty="0"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55" name="三角形 54">
            <a:extLst>
              <a:ext uri="{FF2B5EF4-FFF2-40B4-BE49-F238E27FC236}">
                <a16:creationId xmlns:a16="http://schemas.microsoft.com/office/drawing/2014/main" id="{C786C081-4CFD-26FF-7248-419F609C8A0B}"/>
              </a:ext>
            </a:extLst>
          </p:cNvPr>
          <p:cNvSpPr/>
          <p:nvPr/>
        </p:nvSpPr>
        <p:spPr>
          <a:xfrm rot="12407103">
            <a:off x="2806126" y="5493753"/>
            <a:ext cx="174157" cy="178186"/>
          </a:xfrm>
          <a:prstGeom prst="triangl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6" name="三角形 55">
            <a:extLst>
              <a:ext uri="{FF2B5EF4-FFF2-40B4-BE49-F238E27FC236}">
                <a16:creationId xmlns:a16="http://schemas.microsoft.com/office/drawing/2014/main" id="{375387CD-131B-5307-4AD3-3A23FF50B3F0}"/>
              </a:ext>
            </a:extLst>
          </p:cNvPr>
          <p:cNvSpPr/>
          <p:nvPr/>
        </p:nvSpPr>
        <p:spPr>
          <a:xfrm rot="12407103">
            <a:off x="3093281" y="5559527"/>
            <a:ext cx="174157" cy="178186"/>
          </a:xfrm>
          <a:prstGeom prst="triangl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7" name="三角形 56">
            <a:extLst>
              <a:ext uri="{FF2B5EF4-FFF2-40B4-BE49-F238E27FC236}">
                <a16:creationId xmlns:a16="http://schemas.microsoft.com/office/drawing/2014/main" id="{67D712E2-1D52-36C5-B3C1-CAB99729F8FF}"/>
              </a:ext>
            </a:extLst>
          </p:cNvPr>
          <p:cNvSpPr/>
          <p:nvPr/>
        </p:nvSpPr>
        <p:spPr>
          <a:xfrm rot="12407103">
            <a:off x="3314661" y="5655778"/>
            <a:ext cx="174157" cy="178186"/>
          </a:xfrm>
          <a:prstGeom prst="triangl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8" name="三角形 57">
            <a:extLst>
              <a:ext uri="{FF2B5EF4-FFF2-40B4-BE49-F238E27FC236}">
                <a16:creationId xmlns:a16="http://schemas.microsoft.com/office/drawing/2014/main" id="{BCB8C0A1-55E6-CC55-EBF0-13CB3E1A02AA}"/>
              </a:ext>
            </a:extLst>
          </p:cNvPr>
          <p:cNvSpPr/>
          <p:nvPr/>
        </p:nvSpPr>
        <p:spPr>
          <a:xfrm rot="12407103">
            <a:off x="3526418" y="5800156"/>
            <a:ext cx="174157" cy="178186"/>
          </a:xfrm>
          <a:prstGeom prst="triangl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5" name="グループ化 4">
            <a:extLst>
              <a:ext uri="{FF2B5EF4-FFF2-40B4-BE49-F238E27FC236}">
                <a16:creationId xmlns:a16="http://schemas.microsoft.com/office/drawing/2014/main" id="{CE3D370A-8208-7C27-79FD-AF0ADFB97AF4}"/>
              </a:ext>
            </a:extLst>
          </p:cNvPr>
          <p:cNvGrpSpPr/>
          <p:nvPr/>
        </p:nvGrpSpPr>
        <p:grpSpPr>
          <a:xfrm>
            <a:off x="5057946" y="3777444"/>
            <a:ext cx="5906291" cy="1033891"/>
            <a:chOff x="5057946" y="3777444"/>
            <a:chExt cx="5906291" cy="1033891"/>
          </a:xfrm>
        </p:grpSpPr>
        <p:sp>
          <p:nvSpPr>
            <p:cNvPr id="40" name="フリーフォーム: 図形 39">
              <a:extLst>
                <a:ext uri="{FF2B5EF4-FFF2-40B4-BE49-F238E27FC236}">
                  <a16:creationId xmlns:a16="http://schemas.microsoft.com/office/drawing/2014/main" id="{8B53E8FC-D365-0B32-7124-E5E0BE71C686}"/>
                </a:ext>
              </a:extLst>
            </p:cNvPr>
            <p:cNvSpPr/>
            <p:nvPr/>
          </p:nvSpPr>
          <p:spPr>
            <a:xfrm>
              <a:off x="5191791" y="3943661"/>
              <a:ext cx="5756110" cy="720000"/>
            </a:xfrm>
            <a:custGeom>
              <a:avLst/>
              <a:gdLst>
                <a:gd name="connsiteX0" fmla="*/ 120002 w 5756110"/>
                <a:gd name="connsiteY0" fmla="*/ 0 h 720000"/>
                <a:gd name="connsiteX1" fmla="*/ 1319998 w 5756110"/>
                <a:gd name="connsiteY1" fmla="*/ 0 h 720000"/>
                <a:gd name="connsiteX2" fmla="*/ 1440000 w 5756110"/>
                <a:gd name="connsiteY2" fmla="*/ 120002 h 720000"/>
                <a:gd name="connsiteX3" fmla="*/ 1440000 w 5756110"/>
                <a:gd name="connsiteY3" fmla="*/ 180000 h 720000"/>
                <a:gd name="connsiteX4" fmla="*/ 5696109 w 5756110"/>
                <a:gd name="connsiteY4" fmla="*/ 180000 h 720000"/>
                <a:gd name="connsiteX5" fmla="*/ 5756110 w 5756110"/>
                <a:gd name="connsiteY5" fmla="*/ 240001 h 720000"/>
                <a:gd name="connsiteX6" fmla="*/ 5756110 w 5756110"/>
                <a:gd name="connsiteY6" fmla="*/ 479999 h 720000"/>
                <a:gd name="connsiteX7" fmla="*/ 5696109 w 5756110"/>
                <a:gd name="connsiteY7" fmla="*/ 540000 h 720000"/>
                <a:gd name="connsiteX8" fmla="*/ 1440000 w 5756110"/>
                <a:gd name="connsiteY8" fmla="*/ 540000 h 720000"/>
                <a:gd name="connsiteX9" fmla="*/ 1440000 w 5756110"/>
                <a:gd name="connsiteY9" fmla="*/ 599998 h 720000"/>
                <a:gd name="connsiteX10" fmla="*/ 1319998 w 5756110"/>
                <a:gd name="connsiteY10" fmla="*/ 720000 h 720000"/>
                <a:gd name="connsiteX11" fmla="*/ 120002 w 5756110"/>
                <a:gd name="connsiteY11" fmla="*/ 720000 h 720000"/>
                <a:gd name="connsiteX12" fmla="*/ 0 w 5756110"/>
                <a:gd name="connsiteY12" fmla="*/ 599998 h 720000"/>
                <a:gd name="connsiteX13" fmla="*/ 0 w 5756110"/>
                <a:gd name="connsiteY13" fmla="*/ 120002 h 720000"/>
                <a:gd name="connsiteX14" fmla="*/ 120002 w 5756110"/>
                <a:gd name="connsiteY14" fmla="*/ 0 h 7200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</a:cxnLst>
              <a:rect l="l" t="t" r="r" b="b"/>
              <a:pathLst>
                <a:path w="5756110" h="720000">
                  <a:moveTo>
                    <a:pt x="120002" y="0"/>
                  </a:moveTo>
                  <a:lnTo>
                    <a:pt x="1319998" y="0"/>
                  </a:lnTo>
                  <a:cubicBezTo>
                    <a:pt x="1386273" y="0"/>
                    <a:pt x="1440000" y="53727"/>
                    <a:pt x="1440000" y="120002"/>
                  </a:cubicBezTo>
                  <a:lnTo>
                    <a:pt x="1440000" y="180000"/>
                  </a:lnTo>
                  <a:lnTo>
                    <a:pt x="5696109" y="180000"/>
                  </a:lnTo>
                  <a:cubicBezTo>
                    <a:pt x="5729247" y="180000"/>
                    <a:pt x="5756110" y="206863"/>
                    <a:pt x="5756110" y="240001"/>
                  </a:cubicBezTo>
                  <a:lnTo>
                    <a:pt x="5756110" y="479999"/>
                  </a:lnTo>
                  <a:cubicBezTo>
                    <a:pt x="5756110" y="513137"/>
                    <a:pt x="5729247" y="540000"/>
                    <a:pt x="5696109" y="540000"/>
                  </a:cubicBezTo>
                  <a:lnTo>
                    <a:pt x="1440000" y="540000"/>
                  </a:lnTo>
                  <a:lnTo>
                    <a:pt x="1440000" y="599998"/>
                  </a:lnTo>
                  <a:cubicBezTo>
                    <a:pt x="1440000" y="666273"/>
                    <a:pt x="1386273" y="720000"/>
                    <a:pt x="1319998" y="720000"/>
                  </a:cubicBezTo>
                  <a:lnTo>
                    <a:pt x="120002" y="720000"/>
                  </a:lnTo>
                  <a:cubicBezTo>
                    <a:pt x="53727" y="720000"/>
                    <a:pt x="0" y="666273"/>
                    <a:pt x="0" y="599998"/>
                  </a:cubicBezTo>
                  <a:lnTo>
                    <a:pt x="0" y="120002"/>
                  </a:lnTo>
                  <a:cubicBezTo>
                    <a:pt x="0" y="53727"/>
                    <a:pt x="53727" y="0"/>
                    <a:pt x="120002" y="0"/>
                  </a:cubicBezTo>
                  <a:close/>
                </a:path>
              </a:pathLst>
            </a:cu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square" rtlCol="0" anchor="ctr">
              <a:noAutofit/>
            </a:bodyPr>
            <a:lstStyle/>
            <a:p>
              <a:pPr algn="ctr"/>
              <a:endParaRPr kumimoji="1" lang="ja-JP" altLang="en-US"/>
            </a:p>
          </p:txBody>
        </p:sp>
        <p:cxnSp>
          <p:nvCxnSpPr>
            <p:cNvPr id="13" name="直線矢印コネクタ 12">
              <a:extLst>
                <a:ext uri="{FF2B5EF4-FFF2-40B4-BE49-F238E27FC236}">
                  <a16:creationId xmlns:a16="http://schemas.microsoft.com/office/drawing/2014/main" id="{5CD483E4-D512-D781-3265-318C1C405351}"/>
                </a:ext>
              </a:extLst>
            </p:cNvPr>
            <p:cNvCxnSpPr>
              <a:cxnSpLocks/>
            </p:cNvCxnSpPr>
            <p:nvPr/>
          </p:nvCxnSpPr>
          <p:spPr>
            <a:xfrm>
              <a:off x="6644237" y="3777444"/>
              <a:ext cx="4320000" cy="0"/>
            </a:xfrm>
            <a:prstGeom prst="straightConnector1">
              <a:avLst/>
            </a:prstGeom>
            <a:ln w="57150">
              <a:solidFill>
                <a:schemeClr val="accent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" name="正方形/長方形 17">
              <a:extLst>
                <a:ext uri="{FF2B5EF4-FFF2-40B4-BE49-F238E27FC236}">
                  <a16:creationId xmlns:a16="http://schemas.microsoft.com/office/drawing/2014/main" id="{B0422F8D-E6AF-2D70-A20D-C06663B8D11B}"/>
                </a:ext>
              </a:extLst>
            </p:cNvPr>
            <p:cNvSpPr/>
            <p:nvPr/>
          </p:nvSpPr>
          <p:spPr>
            <a:xfrm>
              <a:off x="5187901" y="4199335"/>
              <a:ext cx="5760000" cy="216000"/>
            </a:xfrm>
            <a:prstGeom prst="rect">
              <a:avLst/>
            </a:prstGeom>
            <a:solidFill>
              <a:srgbClr val="CCECFF"/>
            </a:solidFill>
            <a:ln w="19050">
              <a:solidFill>
                <a:srgbClr val="00206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4" name="楕円 33">
              <a:extLst>
                <a:ext uri="{FF2B5EF4-FFF2-40B4-BE49-F238E27FC236}">
                  <a16:creationId xmlns:a16="http://schemas.microsoft.com/office/drawing/2014/main" id="{CED823C8-B7CB-7495-92A9-CC0FF7A9753D}"/>
                </a:ext>
              </a:extLst>
            </p:cNvPr>
            <p:cNvSpPr/>
            <p:nvPr/>
          </p:nvSpPr>
          <p:spPr>
            <a:xfrm flipV="1">
              <a:off x="6631417" y="4199335"/>
              <a:ext cx="720000" cy="108000"/>
            </a:xfrm>
            <a:prstGeom prst="ellipse">
              <a:avLst/>
            </a:prstGeom>
            <a:solidFill>
              <a:srgbClr val="008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5" name="楕円 34">
              <a:extLst>
                <a:ext uri="{FF2B5EF4-FFF2-40B4-BE49-F238E27FC236}">
                  <a16:creationId xmlns:a16="http://schemas.microsoft.com/office/drawing/2014/main" id="{CA32A7DE-B83F-788E-5BED-95881470C895}"/>
                </a:ext>
              </a:extLst>
            </p:cNvPr>
            <p:cNvSpPr/>
            <p:nvPr/>
          </p:nvSpPr>
          <p:spPr>
            <a:xfrm flipV="1">
              <a:off x="6631417" y="4314153"/>
              <a:ext cx="720000" cy="108000"/>
            </a:xfrm>
            <a:prstGeom prst="ellipse">
              <a:avLst/>
            </a:prstGeom>
            <a:solidFill>
              <a:srgbClr val="008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6" name="正方形/長方形 35">
              <a:extLst>
                <a:ext uri="{FF2B5EF4-FFF2-40B4-BE49-F238E27FC236}">
                  <a16:creationId xmlns:a16="http://schemas.microsoft.com/office/drawing/2014/main" id="{B3997965-390C-48BA-F7D2-3A660ED427DF}"/>
                </a:ext>
              </a:extLst>
            </p:cNvPr>
            <p:cNvSpPr/>
            <p:nvPr/>
          </p:nvSpPr>
          <p:spPr>
            <a:xfrm>
              <a:off x="5508678" y="4164271"/>
              <a:ext cx="4680000" cy="72000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8" name="正方形/長方形 37">
              <a:extLst>
                <a:ext uri="{FF2B5EF4-FFF2-40B4-BE49-F238E27FC236}">
                  <a16:creationId xmlns:a16="http://schemas.microsoft.com/office/drawing/2014/main" id="{8DDE47F2-BC15-E4F9-AC6D-30BFB3795F84}"/>
                </a:ext>
              </a:extLst>
            </p:cNvPr>
            <p:cNvSpPr/>
            <p:nvPr/>
          </p:nvSpPr>
          <p:spPr>
            <a:xfrm>
              <a:off x="5508678" y="4379335"/>
              <a:ext cx="4680000" cy="72000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39" name="グループ化 38">
              <a:extLst>
                <a:ext uri="{FF2B5EF4-FFF2-40B4-BE49-F238E27FC236}">
                  <a16:creationId xmlns:a16="http://schemas.microsoft.com/office/drawing/2014/main" id="{A3014382-C272-25E2-5521-CC86833BB561}"/>
                </a:ext>
              </a:extLst>
            </p:cNvPr>
            <p:cNvGrpSpPr/>
            <p:nvPr/>
          </p:nvGrpSpPr>
          <p:grpSpPr>
            <a:xfrm>
              <a:off x="5057946" y="3803335"/>
              <a:ext cx="143593" cy="1008000"/>
              <a:chOff x="4686791" y="1205824"/>
              <a:chExt cx="143593" cy="1008000"/>
            </a:xfrm>
          </p:grpSpPr>
          <p:sp>
            <p:nvSpPr>
              <p:cNvPr id="59" name="正方形/長方形 58">
                <a:extLst>
                  <a:ext uri="{FF2B5EF4-FFF2-40B4-BE49-F238E27FC236}">
                    <a16:creationId xmlns:a16="http://schemas.microsoft.com/office/drawing/2014/main" id="{FEE6AF2B-AD09-5412-D9C6-7FFE4781522B}"/>
                  </a:ext>
                </a:extLst>
              </p:cNvPr>
              <p:cNvSpPr/>
              <p:nvPr/>
            </p:nvSpPr>
            <p:spPr>
              <a:xfrm>
                <a:off x="4776384" y="1205824"/>
                <a:ext cx="54000" cy="1008000"/>
              </a:xfrm>
              <a:prstGeom prst="rect">
                <a:avLst/>
              </a:prstGeom>
              <a:solidFill>
                <a:schemeClr val="accent1">
                  <a:lumMod val="50000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60" name="正方形/長方形 59">
                <a:extLst>
                  <a:ext uri="{FF2B5EF4-FFF2-40B4-BE49-F238E27FC236}">
                    <a16:creationId xmlns:a16="http://schemas.microsoft.com/office/drawing/2014/main" id="{7A7D8B2F-74CA-DA8B-3A23-C54CA4D4315C}"/>
                  </a:ext>
                </a:extLst>
              </p:cNvPr>
              <p:cNvSpPr/>
              <p:nvPr/>
            </p:nvSpPr>
            <p:spPr>
              <a:xfrm>
                <a:off x="4686791" y="1205824"/>
                <a:ext cx="54000" cy="1008000"/>
              </a:xfrm>
              <a:prstGeom prst="rect">
                <a:avLst/>
              </a:prstGeom>
              <a:solidFill>
                <a:schemeClr val="accent1">
                  <a:lumMod val="50000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sp>
          <p:nvSpPr>
            <p:cNvPr id="41" name="正方形/長方形 40">
              <a:extLst>
                <a:ext uri="{FF2B5EF4-FFF2-40B4-BE49-F238E27FC236}">
                  <a16:creationId xmlns:a16="http://schemas.microsoft.com/office/drawing/2014/main" id="{71827D17-42BA-F41C-8854-1169C5546858}"/>
                </a:ext>
              </a:extLst>
            </p:cNvPr>
            <p:cNvSpPr/>
            <p:nvPr/>
          </p:nvSpPr>
          <p:spPr>
            <a:xfrm>
              <a:off x="6635966" y="4377751"/>
              <a:ext cx="720000" cy="72000"/>
            </a:xfrm>
            <a:prstGeom prst="rect">
              <a:avLst/>
            </a:prstGeom>
            <a:solidFill>
              <a:srgbClr val="C88E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2" name="正方形/長方形 41">
              <a:extLst>
                <a:ext uri="{FF2B5EF4-FFF2-40B4-BE49-F238E27FC236}">
                  <a16:creationId xmlns:a16="http://schemas.microsoft.com/office/drawing/2014/main" id="{C92D0161-E80F-6040-6D7D-356CF6400530}"/>
                </a:ext>
              </a:extLst>
            </p:cNvPr>
            <p:cNvSpPr/>
            <p:nvPr/>
          </p:nvSpPr>
          <p:spPr>
            <a:xfrm>
              <a:off x="6630463" y="4165106"/>
              <a:ext cx="720000" cy="72000"/>
            </a:xfrm>
            <a:prstGeom prst="rect">
              <a:avLst/>
            </a:prstGeom>
            <a:solidFill>
              <a:srgbClr val="C88E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3" name="正方形/長方形 42">
              <a:extLst>
                <a:ext uri="{FF2B5EF4-FFF2-40B4-BE49-F238E27FC236}">
                  <a16:creationId xmlns:a16="http://schemas.microsoft.com/office/drawing/2014/main" id="{5A5A0E2F-EAAD-78D1-4BCC-4BFDDE368A78}"/>
                </a:ext>
              </a:extLst>
            </p:cNvPr>
            <p:cNvSpPr/>
            <p:nvPr/>
          </p:nvSpPr>
          <p:spPr>
            <a:xfrm>
              <a:off x="8083049" y="4377751"/>
              <a:ext cx="720000" cy="72000"/>
            </a:xfrm>
            <a:prstGeom prst="rect">
              <a:avLst/>
            </a:prstGeom>
            <a:solidFill>
              <a:srgbClr val="C88E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52" name="正方形/長方形 51">
              <a:extLst>
                <a:ext uri="{FF2B5EF4-FFF2-40B4-BE49-F238E27FC236}">
                  <a16:creationId xmlns:a16="http://schemas.microsoft.com/office/drawing/2014/main" id="{5FDE8C73-5652-9E18-73C7-0BA6C452D71D}"/>
                </a:ext>
              </a:extLst>
            </p:cNvPr>
            <p:cNvSpPr/>
            <p:nvPr/>
          </p:nvSpPr>
          <p:spPr>
            <a:xfrm>
              <a:off x="8083049" y="4163436"/>
              <a:ext cx="720000" cy="72000"/>
            </a:xfrm>
            <a:prstGeom prst="rect">
              <a:avLst/>
            </a:prstGeom>
            <a:solidFill>
              <a:srgbClr val="C88E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61" name="グループ化 60">
            <a:extLst>
              <a:ext uri="{FF2B5EF4-FFF2-40B4-BE49-F238E27FC236}">
                <a16:creationId xmlns:a16="http://schemas.microsoft.com/office/drawing/2014/main" id="{A7340FFC-9191-AE43-D1FA-91B2FB4BCD70}"/>
              </a:ext>
            </a:extLst>
          </p:cNvPr>
          <p:cNvGrpSpPr/>
          <p:nvPr/>
        </p:nvGrpSpPr>
        <p:grpSpPr>
          <a:xfrm>
            <a:off x="6763233" y="5466098"/>
            <a:ext cx="816341" cy="254995"/>
            <a:chOff x="9259028" y="5416704"/>
            <a:chExt cx="409984" cy="128064"/>
          </a:xfrm>
          <a:solidFill>
            <a:srgbClr val="008000"/>
          </a:solidFill>
        </p:grpSpPr>
        <p:sp>
          <p:nvSpPr>
            <p:cNvPr id="62" name="楕円 61">
              <a:extLst>
                <a:ext uri="{FF2B5EF4-FFF2-40B4-BE49-F238E27FC236}">
                  <a16:creationId xmlns:a16="http://schemas.microsoft.com/office/drawing/2014/main" id="{0DE2DCA9-CAAB-2422-1B56-0AF57318BFFA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259028" y="5416704"/>
              <a:ext cx="409984" cy="61498"/>
            </a:xfrm>
            <a:prstGeom prst="ellips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3" name="楕円 62">
              <a:extLst>
                <a:ext uri="{FF2B5EF4-FFF2-40B4-BE49-F238E27FC236}">
                  <a16:creationId xmlns:a16="http://schemas.microsoft.com/office/drawing/2014/main" id="{A1FCC728-7CB6-2D39-904B-1EFE6C2A026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259028" y="5483270"/>
              <a:ext cx="409984" cy="61498"/>
            </a:xfrm>
            <a:prstGeom prst="ellips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id="{F63172CC-3A7A-AC85-1EE5-0ADDFE27CEAC}"/>
              </a:ext>
            </a:extLst>
          </p:cNvPr>
          <p:cNvSpPr txBox="1"/>
          <p:nvPr/>
        </p:nvSpPr>
        <p:spPr>
          <a:xfrm>
            <a:off x="4150853" y="4895093"/>
            <a:ext cx="2037911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Edge</a:t>
            </a:r>
            <a:r>
              <a:rPr kumimoji="1" lang="ja-JP" altLang="en-US" sz="1600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 </a:t>
            </a:r>
            <a:endParaRPr kumimoji="1" lang="en-US" altLang="ja-JP" sz="1600" dirty="0"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  <a:p>
            <a:pPr algn="ctr"/>
            <a:r>
              <a:rPr kumimoji="1" lang="en-US" altLang="ja-JP" sz="1600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of</a:t>
            </a:r>
            <a:r>
              <a:rPr kumimoji="1" lang="ja-JP" altLang="en-US" sz="1600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 </a:t>
            </a:r>
            <a:r>
              <a:rPr kumimoji="1" lang="en-US" altLang="ja-JP" sz="1600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surgical</a:t>
            </a:r>
            <a:r>
              <a:rPr kumimoji="1" lang="ja-JP" altLang="en-US" sz="1600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 </a:t>
            </a:r>
            <a:r>
              <a:rPr kumimoji="1" lang="en-US" altLang="ja-JP" sz="1600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resection</a:t>
            </a:r>
            <a:endParaRPr kumimoji="1" lang="ja-JP" altLang="en-US" sz="1600" dirty="0"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053890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969</TotalTime>
  <Words>40</Words>
  <Application>Microsoft Office PowerPoint</Application>
  <PresentationFormat>ワイド画面</PresentationFormat>
  <Paragraphs>12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游ゴシック</vt:lpstr>
      <vt:lpstr>游ゴシック Light</vt:lpstr>
      <vt:lpstr>Arial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充弘 増田</dc:creator>
  <cp:lastModifiedBy>美香 三木</cp:lastModifiedBy>
  <cp:revision>29</cp:revision>
  <cp:lastPrinted>2023-08-25T06:27:40Z</cp:lastPrinted>
  <dcterms:created xsi:type="dcterms:W3CDTF">2023-06-05T03:32:48Z</dcterms:created>
  <dcterms:modified xsi:type="dcterms:W3CDTF">2024-08-13T10:17:49Z</dcterms:modified>
</cp:coreProperties>
</file>